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ppt/charts/chart13.xml" ContentType="application/vnd.openxmlformats-officedocument.drawingml.chart+xml"/>
  <Override PartName="/ppt/charts/chart14.xml" ContentType="application/vnd.openxmlformats-officedocument.drawingml.chart+xml"/>
  <Override PartName="/ppt/charts/chart15.xml" ContentType="application/vnd.openxmlformats-officedocument.drawingml.char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ppt/charts/chart11.xml" ContentType="application/vnd.openxmlformats-officedocument.drawingml.chart+xml"/>
  <Override PartName="/ppt/charts/chart12.xml" ContentType="application/vnd.openxmlformats-officedocument.drawingml.chart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10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3" d="100"/>
          <a:sy n="63" d="100"/>
        </p:scale>
        <p:origin x="-1548" y="-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ANALYSIS\RT-PCR%20Analysis\FINAL%20FOR%20REPORT.xlsx" TargetMode="External"/></Relationships>
</file>

<file path=ppt/charts/_rels/chart10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ANALYSIS\RT-PCR%20Analysis\FINAL%20FOR%20REPORT.xlsx" TargetMode="External"/></Relationships>
</file>

<file path=ppt/charts/_rels/chart11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ANALYSIS\RT-PCR%20Analysis\FINAL%20FOR%20REPORT.xlsx" TargetMode="External"/></Relationships>
</file>

<file path=ppt/charts/_rels/chart1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ANALYSIS\RT-PCR%20Analysis\FINAL%20FOR%20REPORT.xlsx" TargetMode="External"/></Relationships>
</file>

<file path=ppt/charts/_rels/chart1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ANALYSIS\RT-PCR%20Analysis\FINAL%20FOR%20REPORT.xlsx" TargetMode="External"/></Relationships>
</file>

<file path=ppt/charts/_rels/chart1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ANALYSIS\RT-PCR%20Analysis\FINAL%20FOR%20REPORT.xlsx" TargetMode="External"/></Relationships>
</file>

<file path=ppt/charts/_rels/chart15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ANALYSIS\RT-PCR%20Analysis\FINAL%20FOR%20REPORT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ANALYSIS\RT-PCR%20Analysis\FINAL%20FOR%20REPORT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ANALYSIS\RT-PCR%20Analysis\FINAL%20FOR%20REPORT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ANALYSIS\RT-PCR%20Analysis\FINAL%20FOR%20REPORT.xlsx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ANALYSIS\RT-PCR%20Analysis\FINAL%20FOR%20REPORT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ANALYSIS\RT-PCR%20Analysis\FINAL%20FOR%20REPORT.xlsx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ANALYSIS\RT-PCR%20Analysis\FINAL%20FOR%20REPORT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ANALYSIS\RT-PCR%20Analysis\FINAL%20FOR%20REPORT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E:\SHUBHRA%20TILL%2019.07.17\ABOUT_SERB_PROJECT_WORK\ANALYSIS\RT-PCR%20Analysis\FINAL%20FOR%20REPOR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100"/>
            </a:pPr>
            <a:r>
              <a:rPr lang="en-US" sz="1100" b="1" i="0" u="none" strike="noStrike" baseline="0" dirty="0" smtClean="0"/>
              <a:t>Cold Responsive</a:t>
            </a:r>
            <a:endParaRPr lang="en-US" dirty="0"/>
          </a:p>
        </c:rich>
      </c:tx>
      <c:layout>
        <c:manualLayout>
          <c:xMode val="edge"/>
          <c:yMode val="edge"/>
          <c:x val="0.27464429864045437"/>
          <c:y val="2.777777777777779E-2"/>
        </c:manualLayout>
      </c:layout>
    </c:title>
    <c:plotArea>
      <c:layout>
        <c:manualLayout>
          <c:layoutTarget val="inner"/>
          <c:xMode val="edge"/>
          <c:yMode val="edge"/>
          <c:x val="0.15168419947506628"/>
          <c:y val="5.6504811898512711E-2"/>
          <c:w val="0.78964913385826774"/>
          <c:h val="0.72079469233012805"/>
        </c:manualLayout>
      </c:layout>
      <c:barChart>
        <c:barDir val="col"/>
        <c:grouping val="clustered"/>
        <c:ser>
          <c:idx val="0"/>
          <c:order val="0"/>
          <c:tx>
            <c:strRef>
              <c:f>Cold!$A$22</c:f>
              <c:strCache>
                <c:ptCount val="1"/>
                <c:pt idx="0">
                  <c:v>COR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prstClr val="black"/>
              </a:solidFill>
            </a:ln>
          </c:spPr>
          <c:errBars>
            <c:errBarType val="both"/>
            <c:errValType val="cust"/>
            <c:plus>
              <c:numRef>
                <c:f>Cold!$F$22:$H$22</c:f>
                <c:numCache>
                  <c:formatCode>General</c:formatCode>
                  <c:ptCount val="3"/>
                  <c:pt idx="0">
                    <c:v>8.3862864248514257E-4</c:v>
                  </c:pt>
                  <c:pt idx="1">
                    <c:v>2.9886575213629221E-2</c:v>
                  </c:pt>
                  <c:pt idx="2">
                    <c:v>1.3496547132509416E-2</c:v>
                  </c:pt>
                </c:numCache>
              </c:numRef>
            </c:plus>
            <c:minus>
              <c:numRef>
                <c:f>Cold!$F$22:$H$22</c:f>
                <c:numCache>
                  <c:formatCode>General</c:formatCode>
                  <c:ptCount val="3"/>
                  <c:pt idx="0">
                    <c:v>8.3862864248514257E-4</c:v>
                  </c:pt>
                  <c:pt idx="1">
                    <c:v>2.9886575213629221E-2</c:v>
                  </c:pt>
                  <c:pt idx="2">
                    <c:v>1.3496547132509416E-2</c:v>
                  </c:pt>
                </c:numCache>
              </c:numRef>
            </c:minus>
          </c:errBars>
          <c:cat>
            <c:strRef>
              <c:f>Cold!$B$1:$D$1</c:f>
              <c:strCache>
                <c:ptCount val="3"/>
                <c:pt idx="0">
                  <c:v>COLD_24H</c:v>
                </c:pt>
                <c:pt idx="1">
                  <c:v>COLD_48H</c:v>
                </c:pt>
                <c:pt idx="2">
                  <c:v>COLD_72H</c:v>
                </c:pt>
              </c:strCache>
            </c:strRef>
          </c:cat>
          <c:val>
            <c:numRef>
              <c:f>Cold!$B$22:$D$22</c:f>
              <c:numCache>
                <c:formatCode>General</c:formatCode>
                <c:ptCount val="3"/>
                <c:pt idx="0">
                  <c:v>1.8532631968383594E-3</c:v>
                </c:pt>
                <c:pt idx="1">
                  <c:v>0.50878339791677252</c:v>
                </c:pt>
                <c:pt idx="2">
                  <c:v>0.58103782908774204</c:v>
                </c:pt>
              </c:numCache>
            </c:numRef>
          </c:val>
        </c:ser>
        <c:axId val="59648640"/>
        <c:axId val="61534592"/>
      </c:barChart>
      <c:catAx>
        <c:axId val="59648640"/>
        <c:scaling>
          <c:orientation val="minMax"/>
        </c:scaling>
        <c:axPos val="b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61534592"/>
        <c:crosses val="autoZero"/>
        <c:auto val="1"/>
        <c:lblAlgn val="ctr"/>
        <c:lblOffset val="100"/>
      </c:catAx>
      <c:valAx>
        <c:axId val="61534592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b="1" i="0" baseline="0"/>
                  <a:t>RQ</a:t>
                </a:r>
                <a:endParaRPr lang="en-US" sz="1000"/>
              </a:p>
            </c:rich>
          </c:tx>
          <c:layout>
            <c:manualLayout>
              <c:xMode val="edge"/>
              <c:yMode val="edge"/>
              <c:x val="3.4333325223099037E-2"/>
              <c:y val="0.29272747156605428"/>
            </c:manualLayout>
          </c:layout>
        </c:title>
        <c:numFmt formatCode="General" sourceLinked="1"/>
        <c:tickLblPos val="nextTo"/>
        <c:spPr>
          <a:ln w="19050">
            <a:solidFill>
              <a:prstClr val="black"/>
            </a:solidFill>
          </a:ln>
        </c:spPr>
        <c:crossAx val="59648640"/>
        <c:crosses val="autoZero"/>
        <c:crossBetween val="between"/>
      </c:valAx>
      <c:spPr>
        <a:noFill/>
      </c:spPr>
    </c:plotArea>
    <c:plotVisOnly val="1"/>
  </c:chart>
  <c:externalData r:id="rId1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100"/>
            </a:pPr>
            <a:r>
              <a:rPr lang="en-US" dirty="0" smtClean="0"/>
              <a:t>Potassium</a:t>
            </a:r>
            <a:r>
              <a:rPr lang="en-US" baseline="0" dirty="0" smtClean="0"/>
              <a:t>  </a:t>
            </a:r>
            <a:r>
              <a:rPr lang="en-US" dirty="0" smtClean="0"/>
              <a:t>channel</a:t>
            </a:r>
            <a:endParaRPr lang="en-US" dirty="0"/>
          </a:p>
        </c:rich>
      </c:tx>
      <c:layout>
        <c:manualLayout>
          <c:xMode val="edge"/>
          <c:yMode val="edge"/>
          <c:x val="0.2108946557397309"/>
          <c:y val="0"/>
        </c:manualLayout>
      </c:layout>
    </c:title>
    <c:plotArea>
      <c:layout>
        <c:manualLayout>
          <c:layoutTarget val="inner"/>
          <c:xMode val="edge"/>
          <c:yMode val="edge"/>
          <c:x val="0.14371437288554526"/>
          <c:y val="5.9828624363131098E-2"/>
          <c:w val="0.89044225721784753"/>
          <c:h val="0.50026246719160095"/>
        </c:manualLayout>
      </c:layout>
      <c:barChart>
        <c:barDir val="col"/>
        <c:grouping val="clustered"/>
        <c:ser>
          <c:idx val="0"/>
          <c:order val="0"/>
          <c:tx>
            <c:strRef>
              <c:f>SALt!$A$40</c:f>
              <c:strCache>
                <c:ptCount val="1"/>
                <c:pt idx="0">
                  <c:v>K.channel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prstClr val="black"/>
              </a:solidFill>
            </a:ln>
          </c:spPr>
          <c:errBars>
            <c:errBarType val="both"/>
            <c:errValType val="cust"/>
            <c:plus>
              <c:numRef>
                <c:f>SALt!$H$40:$L$40</c:f>
                <c:numCache>
                  <c:formatCode>General</c:formatCode>
                  <c:ptCount val="5"/>
                  <c:pt idx="0">
                    <c:v>2.077479723126315E-3</c:v>
                  </c:pt>
                  <c:pt idx="1">
                    <c:v>1.2301536672304169E-2</c:v>
                  </c:pt>
                  <c:pt idx="2">
                    <c:v>3.9032294321501961E-3</c:v>
                  </c:pt>
                  <c:pt idx="3">
                    <c:v>6.7450915857386277E-3</c:v>
                  </c:pt>
                  <c:pt idx="4">
                    <c:v>1.6008897526040193E-3</c:v>
                  </c:pt>
                </c:numCache>
              </c:numRef>
            </c:plus>
            <c:minus>
              <c:numRef>
                <c:f>SALt!$H$40:$L$40</c:f>
                <c:numCache>
                  <c:formatCode>General</c:formatCode>
                  <c:ptCount val="5"/>
                  <c:pt idx="0">
                    <c:v>2.077479723126315E-3</c:v>
                  </c:pt>
                  <c:pt idx="1">
                    <c:v>1.2301536672304169E-2</c:v>
                  </c:pt>
                  <c:pt idx="2">
                    <c:v>3.9032294321501961E-3</c:v>
                  </c:pt>
                  <c:pt idx="3">
                    <c:v>6.7450915857386277E-3</c:v>
                  </c:pt>
                  <c:pt idx="4">
                    <c:v>1.6008897526040193E-3</c:v>
                  </c:pt>
                </c:numCache>
              </c:numRef>
            </c:minus>
          </c:errBars>
          <c:cat>
            <c:strRef>
              <c:f>SALt!$B$1:$F$1</c:f>
              <c:strCache>
                <c:ptCount val="5"/>
                <c:pt idx="0">
                  <c:v>SALT_25</c:v>
                </c:pt>
                <c:pt idx="1">
                  <c:v>SALT_50</c:v>
                </c:pt>
                <c:pt idx="2">
                  <c:v>SALT_75</c:v>
                </c:pt>
                <c:pt idx="3">
                  <c:v>SALT_100</c:v>
                </c:pt>
                <c:pt idx="4">
                  <c:v>SALT_125</c:v>
                </c:pt>
              </c:strCache>
            </c:strRef>
          </c:cat>
          <c:val>
            <c:numRef>
              <c:f>SALt!$B$40:$F$40</c:f>
              <c:numCache>
                <c:formatCode>General</c:formatCode>
                <c:ptCount val="5"/>
                <c:pt idx="0">
                  <c:v>0.22416423154736848</c:v>
                </c:pt>
                <c:pt idx="1">
                  <c:v>0.28849105655121016</c:v>
                </c:pt>
                <c:pt idx="2">
                  <c:v>0.54142372032866359</c:v>
                </c:pt>
                <c:pt idx="3">
                  <c:v>0.7465816734769336</c:v>
                </c:pt>
                <c:pt idx="4">
                  <c:v>0.79263056174024715</c:v>
                </c:pt>
              </c:numCache>
            </c:numRef>
          </c:val>
        </c:ser>
        <c:axId val="67188224"/>
        <c:axId val="67189760"/>
      </c:barChart>
      <c:catAx>
        <c:axId val="67188224"/>
        <c:scaling>
          <c:orientation val="minMax"/>
        </c:scaling>
        <c:axPos val="b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67189760"/>
        <c:crosses val="autoZero"/>
        <c:auto val="1"/>
        <c:lblAlgn val="ctr"/>
        <c:lblOffset val="100"/>
      </c:catAx>
      <c:valAx>
        <c:axId val="67189760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b="1" i="0" baseline="0"/>
                  <a:t>RQ</a:t>
                </a:r>
                <a:endParaRPr lang="en-US" sz="1000"/>
              </a:p>
            </c:rich>
          </c:tx>
          <c:layout>
            <c:manualLayout>
              <c:xMode val="edge"/>
              <c:yMode val="edge"/>
              <c:x val="5.773716651476064E-3"/>
              <c:y val="0.35744403273120268"/>
            </c:manualLayout>
          </c:layout>
        </c:title>
        <c:numFmt formatCode="General" sourceLinked="1"/>
        <c:tickLblPos val="nextTo"/>
        <c:spPr>
          <a:ln w="19050">
            <a:solidFill>
              <a:prstClr val="black"/>
            </a:solidFill>
          </a:ln>
        </c:spPr>
        <c:crossAx val="67188224"/>
        <c:crosses val="autoZero"/>
        <c:crossBetween val="between"/>
      </c:valAx>
      <c:spPr>
        <a:noFill/>
      </c:spPr>
    </c:plotArea>
    <c:plotVisOnly val="1"/>
  </c:chart>
  <c:externalData r:id="rId1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100"/>
            </a:pPr>
            <a:r>
              <a:rPr lang="en-US" dirty="0" err="1" smtClean="0"/>
              <a:t>Proline</a:t>
            </a:r>
            <a:r>
              <a:rPr lang="en-US" dirty="0" smtClean="0"/>
              <a:t> transporter</a:t>
            </a:r>
            <a:endParaRPr lang="en-US" dirty="0"/>
          </a:p>
        </c:rich>
      </c:tx>
      <c:layout>
        <c:manualLayout>
          <c:xMode val="edge"/>
          <c:yMode val="edge"/>
          <c:x val="0.16703537965413331"/>
          <c:y val="0.1388888888888889"/>
        </c:manualLayout>
      </c:layout>
    </c:title>
    <c:plotArea>
      <c:layout>
        <c:manualLayout>
          <c:layoutTarget val="inner"/>
          <c:xMode val="edge"/>
          <c:yMode val="edge"/>
          <c:x val="0.12516256231166559"/>
          <c:y val="0.1350696052699295"/>
          <c:w val="0.84203458942632159"/>
          <c:h val="0.69126524625598273"/>
        </c:manualLayout>
      </c:layout>
      <c:barChart>
        <c:barDir val="col"/>
        <c:grouping val="clustered"/>
        <c:ser>
          <c:idx val="0"/>
          <c:order val="0"/>
          <c:tx>
            <c:strRef>
              <c:f>Drought!$A$61</c:f>
              <c:strCache>
                <c:ptCount val="1"/>
                <c:pt idx="0">
                  <c:v>Pro.transporter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prstClr val="black"/>
              </a:solidFill>
            </a:ln>
          </c:spPr>
          <c:errBars>
            <c:errBarType val="both"/>
            <c:errValType val="cust"/>
            <c:plus>
              <c:numRef>
                <c:f>Drought!$G$61:$J$61</c:f>
                <c:numCache>
                  <c:formatCode>General</c:formatCode>
                  <c:ptCount val="4"/>
                  <c:pt idx="0">
                    <c:v>6.4412478018626929E-2</c:v>
                  </c:pt>
                  <c:pt idx="1">
                    <c:v>7.7141814293546412E-2</c:v>
                  </c:pt>
                  <c:pt idx="2">
                    <c:v>1.440376513276982E-2</c:v>
                  </c:pt>
                  <c:pt idx="3">
                    <c:v>2.6512968760592E-2</c:v>
                  </c:pt>
                </c:numCache>
              </c:numRef>
            </c:plus>
            <c:minus>
              <c:numRef>
                <c:f>Drought!$G$61:$J$61</c:f>
                <c:numCache>
                  <c:formatCode>General</c:formatCode>
                  <c:ptCount val="4"/>
                  <c:pt idx="0">
                    <c:v>6.4412478018626929E-2</c:v>
                  </c:pt>
                  <c:pt idx="1">
                    <c:v>7.7141814293546412E-2</c:v>
                  </c:pt>
                  <c:pt idx="2">
                    <c:v>1.440376513276982E-2</c:v>
                  </c:pt>
                  <c:pt idx="3">
                    <c:v>2.6512968760592E-2</c:v>
                  </c:pt>
                </c:numCache>
              </c:numRef>
            </c:minus>
          </c:errBars>
          <c:cat>
            <c:strRef>
              <c:f>Drought!$B$1:$E$1</c:f>
              <c:strCache>
                <c:ptCount val="4"/>
                <c:pt idx="0">
                  <c:v>100% FC</c:v>
                </c:pt>
                <c:pt idx="1">
                  <c:v>60% FC</c:v>
                </c:pt>
                <c:pt idx="2">
                  <c:v>40% FC</c:v>
                </c:pt>
                <c:pt idx="3">
                  <c:v>20% FC</c:v>
                </c:pt>
              </c:strCache>
            </c:strRef>
          </c:cat>
          <c:val>
            <c:numRef>
              <c:f>Drought!$B$61:$E$61</c:f>
              <c:numCache>
                <c:formatCode>General</c:formatCode>
                <c:ptCount val="4"/>
                <c:pt idx="0">
                  <c:v>0.31433536500044595</c:v>
                </c:pt>
                <c:pt idx="1">
                  <c:v>0.31659985503379334</c:v>
                </c:pt>
                <c:pt idx="2">
                  <c:v>0.36027763467642426</c:v>
                </c:pt>
                <c:pt idx="3">
                  <c:v>2.0890803756811636</c:v>
                </c:pt>
              </c:numCache>
            </c:numRef>
          </c:val>
        </c:ser>
        <c:axId val="67206144"/>
        <c:axId val="67220224"/>
      </c:barChart>
      <c:catAx>
        <c:axId val="67206144"/>
        <c:scaling>
          <c:orientation val="minMax"/>
        </c:scaling>
        <c:axPos val="b"/>
        <c:tickLblPos val="nextTo"/>
        <c:spPr>
          <a:ln w="15875"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67220224"/>
        <c:crosses val="autoZero"/>
        <c:auto val="1"/>
        <c:lblAlgn val="ctr"/>
        <c:lblOffset val="100"/>
      </c:catAx>
      <c:valAx>
        <c:axId val="67220224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b="1" i="0" baseline="0"/>
                  <a:t>RQ</a:t>
                </a:r>
                <a:endParaRPr lang="en-US" sz="1000"/>
              </a:p>
            </c:rich>
          </c:tx>
          <c:layout/>
        </c:title>
        <c:numFmt formatCode="General" sourceLinked="1"/>
        <c:tickLblPos val="nextTo"/>
        <c:spPr>
          <a:ln w="19050">
            <a:solidFill>
              <a:prstClr val="black"/>
            </a:solidFill>
          </a:ln>
        </c:spPr>
        <c:crossAx val="67206144"/>
        <c:crosses val="autoZero"/>
        <c:crossBetween val="between"/>
      </c:valAx>
      <c:spPr>
        <a:noFill/>
      </c:spPr>
    </c:plotArea>
    <c:plotVisOnly val="1"/>
  </c:chart>
  <c:externalData r:id="rId1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100"/>
            </a:pPr>
            <a:r>
              <a:rPr lang="en-US" dirty="0" smtClean="0"/>
              <a:t>Drought</a:t>
            </a:r>
            <a:r>
              <a:rPr lang="en-US" baseline="0" dirty="0" smtClean="0"/>
              <a:t> </a:t>
            </a:r>
            <a:r>
              <a:rPr lang="en-US" dirty="0" smtClean="0"/>
              <a:t>induced Protein</a:t>
            </a:r>
            <a:endParaRPr lang="en-US" dirty="0"/>
          </a:p>
        </c:rich>
      </c:tx>
      <c:layout>
        <c:manualLayout>
          <c:xMode val="edge"/>
          <c:yMode val="edge"/>
          <c:x val="0.16370607863320158"/>
          <c:y val="0.18790849673202623"/>
        </c:manualLayout>
      </c:layout>
    </c:title>
    <c:plotArea>
      <c:layout>
        <c:manualLayout>
          <c:layoutTarget val="inner"/>
          <c:xMode val="edge"/>
          <c:yMode val="edge"/>
          <c:x val="0.12516256231166559"/>
          <c:y val="0.13727548762287073"/>
          <c:w val="0.81118702362478978"/>
          <c:h val="0.69126524625598273"/>
        </c:manualLayout>
      </c:layout>
      <c:barChart>
        <c:barDir val="col"/>
        <c:grouping val="clustered"/>
        <c:ser>
          <c:idx val="0"/>
          <c:order val="0"/>
          <c:tx>
            <c:strRef>
              <c:f>Drought!$A$62</c:f>
              <c:strCache>
                <c:ptCount val="1"/>
                <c:pt idx="0">
                  <c:v>Drought_indP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prstClr val="black"/>
              </a:solidFill>
            </a:ln>
          </c:spPr>
          <c:errBars>
            <c:errBarType val="both"/>
            <c:errValType val="cust"/>
            <c:plus>
              <c:numRef>
                <c:f>Drought!$G$62:$J$62</c:f>
                <c:numCache>
                  <c:formatCode>General</c:formatCode>
                  <c:ptCount val="4"/>
                  <c:pt idx="0">
                    <c:v>5.0345295713701013E-2</c:v>
                  </c:pt>
                  <c:pt idx="1">
                    <c:v>2.0202040738491016E-3</c:v>
                  </c:pt>
                  <c:pt idx="2">
                    <c:v>8.9943982566940484E-4</c:v>
                  </c:pt>
                  <c:pt idx="3">
                    <c:v>2.9099565366170952E-2</c:v>
                  </c:pt>
                </c:numCache>
              </c:numRef>
            </c:plus>
            <c:minus>
              <c:numRef>
                <c:f>Drought!$G$62:$J$62</c:f>
                <c:numCache>
                  <c:formatCode>General</c:formatCode>
                  <c:ptCount val="4"/>
                  <c:pt idx="0">
                    <c:v>5.0345295713701013E-2</c:v>
                  </c:pt>
                  <c:pt idx="1">
                    <c:v>2.0202040738491016E-3</c:v>
                  </c:pt>
                  <c:pt idx="2">
                    <c:v>8.9943982566940484E-4</c:v>
                  </c:pt>
                  <c:pt idx="3">
                    <c:v>2.9099565366170952E-2</c:v>
                  </c:pt>
                </c:numCache>
              </c:numRef>
            </c:minus>
          </c:errBars>
          <c:cat>
            <c:strRef>
              <c:f>Drought!$B$1:$E$1</c:f>
              <c:strCache>
                <c:ptCount val="4"/>
                <c:pt idx="0">
                  <c:v>100% FC</c:v>
                </c:pt>
                <c:pt idx="1">
                  <c:v>60% FC</c:v>
                </c:pt>
                <c:pt idx="2">
                  <c:v>40% FC</c:v>
                </c:pt>
                <c:pt idx="3">
                  <c:v>20% FC</c:v>
                </c:pt>
              </c:strCache>
            </c:strRef>
          </c:cat>
          <c:val>
            <c:numRef>
              <c:f>Drought!$B$62:$E$62</c:f>
              <c:numCache>
                <c:formatCode>General</c:formatCode>
                <c:ptCount val="4"/>
                <c:pt idx="0">
                  <c:v>0.43091672517973933</c:v>
                </c:pt>
                <c:pt idx="1">
                  <c:v>0.67286360807535162</c:v>
                </c:pt>
                <c:pt idx="2">
                  <c:v>0.89989619617575067</c:v>
                </c:pt>
                <c:pt idx="3">
                  <c:v>1.70335778447033</c:v>
                </c:pt>
              </c:numCache>
            </c:numRef>
          </c:val>
        </c:ser>
        <c:axId val="67511040"/>
        <c:axId val="67512576"/>
      </c:barChart>
      <c:catAx>
        <c:axId val="67511040"/>
        <c:scaling>
          <c:orientation val="minMax"/>
        </c:scaling>
        <c:axPos val="b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sz="1050" b="1"/>
            </a:pPr>
            <a:endParaRPr lang="en-US"/>
          </a:p>
        </c:txPr>
        <c:crossAx val="67512576"/>
        <c:crosses val="autoZero"/>
        <c:auto val="1"/>
        <c:lblAlgn val="ctr"/>
        <c:lblOffset val="100"/>
      </c:catAx>
      <c:valAx>
        <c:axId val="67512576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b="1" i="0" baseline="0"/>
                  <a:t>RQ</a:t>
                </a:r>
                <a:endParaRPr lang="en-US" sz="1000"/>
              </a:p>
            </c:rich>
          </c:tx>
          <c:layout>
            <c:manualLayout>
              <c:xMode val="edge"/>
              <c:yMode val="edge"/>
              <c:x val="2.3696314010367918E-2"/>
              <c:y val="0.46938654726982676"/>
            </c:manualLayout>
          </c:layout>
        </c:title>
        <c:numFmt formatCode="General" sourceLinked="1"/>
        <c:tickLblPos val="nextTo"/>
        <c:spPr>
          <a:ln w="19050">
            <a:solidFill>
              <a:prstClr val="black"/>
            </a:solidFill>
          </a:ln>
        </c:spPr>
        <c:crossAx val="67511040"/>
        <c:crosses val="autoZero"/>
        <c:crossBetween val="between"/>
      </c:valAx>
      <c:spPr>
        <a:noFill/>
        <a:ln w="25400">
          <a:noFill/>
        </a:ln>
      </c:spPr>
    </c:plotArea>
    <c:plotVisOnly val="1"/>
  </c:chart>
  <c:externalData r:id="rId1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layout>
        <c:manualLayout>
          <c:xMode val="edge"/>
          <c:yMode val="edge"/>
          <c:x val="0.45616338747197777"/>
          <c:y val="0.12648809523809523"/>
        </c:manualLayout>
      </c:layout>
      <c:txPr>
        <a:bodyPr/>
        <a:lstStyle/>
        <a:p>
          <a:pPr>
            <a:defRPr sz="1100"/>
          </a:pPr>
          <a:endParaRPr lang="en-US"/>
        </a:p>
      </c:txPr>
    </c:title>
    <c:plotArea>
      <c:layout>
        <c:manualLayout>
          <c:layoutTarget val="inner"/>
          <c:xMode val="edge"/>
          <c:yMode val="edge"/>
          <c:x val="0.1410753343332084"/>
          <c:y val="9.4219932067315049E-2"/>
          <c:w val="0.80436117360329962"/>
          <c:h val="0.60139596521023109"/>
        </c:manualLayout>
      </c:layout>
      <c:barChart>
        <c:barDir val="col"/>
        <c:grouping val="clustered"/>
        <c:ser>
          <c:idx val="0"/>
          <c:order val="0"/>
          <c:tx>
            <c:strRef>
              <c:f>Drought!$A$60</c:f>
              <c:strCache>
                <c:ptCount val="1"/>
                <c:pt idx="0">
                  <c:v>PLD</c:v>
                </c:pt>
              </c:strCache>
            </c:strRef>
          </c:tx>
          <c:spPr>
            <a:solidFill>
              <a:schemeClr val="bg1"/>
            </a:solidFill>
            <a:ln w="19050" cap="flat" cmpd="sng" algn="ctr">
              <a:solidFill>
                <a:prstClr val="black"/>
              </a:solidFill>
              <a:prstDash val="solid"/>
            </a:ln>
            <a:effectLst/>
          </c:spPr>
          <c:errBars>
            <c:errBarType val="both"/>
            <c:errValType val="cust"/>
            <c:plus>
              <c:numRef>
                <c:f>Drought!$G$60:$J$60</c:f>
                <c:numCache>
                  <c:formatCode>General</c:formatCode>
                  <c:ptCount val="4"/>
                  <c:pt idx="0">
                    <c:v>2.8697221607674225E-2</c:v>
                  </c:pt>
                  <c:pt idx="1">
                    <c:v>3.4661667306984258E-2</c:v>
                  </c:pt>
                  <c:pt idx="2">
                    <c:v>9.7771654634657874E-3</c:v>
                  </c:pt>
                  <c:pt idx="3">
                    <c:v>2.3334523778021491E-5</c:v>
                  </c:pt>
                </c:numCache>
              </c:numRef>
            </c:plus>
            <c:minus>
              <c:numRef>
                <c:f>Drought!$G$60:$J$60</c:f>
                <c:numCache>
                  <c:formatCode>General</c:formatCode>
                  <c:ptCount val="4"/>
                  <c:pt idx="0">
                    <c:v>2.8697221607674225E-2</c:v>
                  </c:pt>
                  <c:pt idx="1">
                    <c:v>3.4661667306984258E-2</c:v>
                  </c:pt>
                  <c:pt idx="2">
                    <c:v>9.7771654634657874E-3</c:v>
                  </c:pt>
                  <c:pt idx="3">
                    <c:v>2.3334523778021491E-5</c:v>
                  </c:pt>
                </c:numCache>
              </c:numRef>
            </c:minus>
          </c:errBars>
          <c:cat>
            <c:strRef>
              <c:f>Drought!$B$1:$E$1</c:f>
              <c:strCache>
                <c:ptCount val="4"/>
                <c:pt idx="0">
                  <c:v>100% FC</c:v>
                </c:pt>
                <c:pt idx="1">
                  <c:v>60% FC</c:v>
                </c:pt>
                <c:pt idx="2">
                  <c:v>40% FC</c:v>
                </c:pt>
                <c:pt idx="3">
                  <c:v>20% FC</c:v>
                </c:pt>
              </c:strCache>
            </c:strRef>
          </c:cat>
          <c:val>
            <c:numRef>
              <c:f>Drought!$B$60:$E$60</c:f>
              <c:numCache>
                <c:formatCode>General</c:formatCode>
                <c:ptCount val="4"/>
                <c:pt idx="0">
                  <c:v>1.6859654828935451</c:v>
                </c:pt>
                <c:pt idx="1">
                  <c:v>0.98698461403599369</c:v>
                </c:pt>
                <c:pt idx="2">
                  <c:v>0.92836851462481085</c:v>
                </c:pt>
                <c:pt idx="3">
                  <c:v>0.3709218086813959</c:v>
                </c:pt>
              </c:numCache>
            </c:numRef>
          </c:val>
        </c:ser>
        <c:axId val="67533056"/>
        <c:axId val="67559424"/>
      </c:barChart>
      <c:catAx>
        <c:axId val="67533056"/>
        <c:scaling>
          <c:orientation val="minMax"/>
        </c:scaling>
        <c:axPos val="b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67559424"/>
        <c:crosses val="autoZero"/>
        <c:auto val="1"/>
        <c:lblAlgn val="ctr"/>
        <c:lblOffset val="100"/>
      </c:catAx>
      <c:valAx>
        <c:axId val="67559424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b="1" i="0" baseline="0"/>
                  <a:t>RQ</a:t>
                </a:r>
                <a:endParaRPr lang="en-US" sz="1000"/>
              </a:p>
            </c:rich>
          </c:tx>
          <c:layout>
            <c:manualLayout>
              <c:xMode val="edge"/>
              <c:yMode val="edge"/>
              <c:x val="7.6636907006846049E-3"/>
              <c:y val="0.41577548315867352"/>
            </c:manualLayout>
          </c:layout>
        </c:title>
        <c:numFmt formatCode="General" sourceLinked="1"/>
        <c:tickLblPos val="nextTo"/>
        <c:spPr>
          <a:ln w="19050">
            <a:solidFill>
              <a:prstClr val="black"/>
            </a:solidFill>
          </a:ln>
        </c:spPr>
        <c:crossAx val="67533056"/>
        <c:crosses val="autoZero"/>
        <c:crossBetween val="between"/>
      </c:valAx>
      <c:spPr>
        <a:noFill/>
        <a:ln>
          <a:noFill/>
        </a:ln>
      </c:spPr>
    </c:plotArea>
    <c:plotVisOnly val="1"/>
  </c:chart>
  <c:externalData r:id="rId1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layout>
        <c:manualLayout>
          <c:xMode val="edge"/>
          <c:yMode val="edge"/>
          <c:x val="0.22899989997377695"/>
          <c:y val="8.3333333333333343E-2"/>
        </c:manualLayout>
      </c:layout>
      <c:txPr>
        <a:bodyPr/>
        <a:lstStyle/>
        <a:p>
          <a:pPr>
            <a:defRPr sz="1100"/>
          </a:pPr>
          <a:endParaRPr lang="en-US"/>
        </a:p>
      </c:txPr>
    </c:title>
    <c:plotArea>
      <c:layout>
        <c:manualLayout>
          <c:layoutTarget val="inner"/>
          <c:xMode val="edge"/>
          <c:yMode val="edge"/>
          <c:x val="0.13941557070573926"/>
          <c:y val="0.10752924212745861"/>
          <c:w val="0.8066628814795116"/>
          <c:h val="0.65888907814248598"/>
        </c:manualLayout>
      </c:layout>
      <c:barChart>
        <c:barDir val="col"/>
        <c:grouping val="clustered"/>
        <c:ser>
          <c:idx val="0"/>
          <c:order val="0"/>
          <c:tx>
            <c:strRef>
              <c:f>Cold!$A$51</c:f>
              <c:strCache>
                <c:ptCount val="1"/>
                <c:pt idx="0">
                  <c:v>Cu-chaperone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prstClr val="black"/>
              </a:solidFill>
            </a:ln>
          </c:spPr>
          <c:errBars>
            <c:errBarType val="both"/>
            <c:errValType val="cust"/>
            <c:plus>
              <c:numRef>
                <c:f>Cold!$F$51:$H$51</c:f>
                <c:numCache>
                  <c:formatCode>General</c:formatCode>
                  <c:ptCount val="3"/>
                  <c:pt idx="0">
                    <c:v>5.5302821356599053E-3</c:v>
                  </c:pt>
                  <c:pt idx="1">
                    <c:v>6.5661935700978991E-3</c:v>
                  </c:pt>
                  <c:pt idx="2">
                    <c:v>7.6989786335575714E-3</c:v>
                  </c:pt>
                </c:numCache>
              </c:numRef>
            </c:plus>
            <c:minus>
              <c:numRef>
                <c:f>Cold!$F$51:$H$51</c:f>
                <c:numCache>
                  <c:formatCode>General</c:formatCode>
                  <c:ptCount val="3"/>
                  <c:pt idx="0">
                    <c:v>5.5302821356599053E-3</c:v>
                  </c:pt>
                  <c:pt idx="1">
                    <c:v>6.5661935700978991E-3</c:v>
                  </c:pt>
                  <c:pt idx="2">
                    <c:v>7.6989786335575714E-3</c:v>
                  </c:pt>
                </c:numCache>
              </c:numRef>
            </c:minus>
          </c:errBars>
          <c:cat>
            <c:strRef>
              <c:f>Cold!$B$1:$D$1</c:f>
              <c:strCache>
                <c:ptCount val="3"/>
                <c:pt idx="0">
                  <c:v>COLD_24H</c:v>
                </c:pt>
                <c:pt idx="1">
                  <c:v>COLD_48H</c:v>
                </c:pt>
                <c:pt idx="2">
                  <c:v>COLD_72H</c:v>
                </c:pt>
              </c:strCache>
            </c:strRef>
          </c:cat>
          <c:val>
            <c:numRef>
              <c:f>Cold!$B$51:$D$51</c:f>
              <c:numCache>
                <c:formatCode>General</c:formatCode>
                <c:ptCount val="3"/>
                <c:pt idx="0">
                  <c:v>9.6755735882594326E-2</c:v>
                </c:pt>
                <c:pt idx="1">
                  <c:v>0.17622157855268292</c:v>
                </c:pt>
                <c:pt idx="2">
                  <c:v>0.22621468628974228</c:v>
                </c:pt>
              </c:numCache>
            </c:numRef>
          </c:val>
        </c:ser>
        <c:axId val="67067904"/>
        <c:axId val="67069440"/>
      </c:barChart>
      <c:catAx>
        <c:axId val="67067904"/>
        <c:scaling>
          <c:orientation val="minMax"/>
        </c:scaling>
        <c:axPos val="b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67069440"/>
        <c:crosses val="autoZero"/>
        <c:auto val="1"/>
        <c:lblAlgn val="ctr"/>
        <c:lblOffset val="100"/>
      </c:catAx>
      <c:valAx>
        <c:axId val="67069440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b="1" i="0" baseline="0"/>
                  <a:t>RQ</a:t>
                </a:r>
                <a:endParaRPr lang="en-US" sz="1000"/>
              </a:p>
            </c:rich>
          </c:tx>
          <c:layout>
            <c:manualLayout>
              <c:xMode val="edge"/>
              <c:yMode val="edge"/>
              <c:x val="8.5833313057747551E-2"/>
              <c:y val="0.22590915718868476"/>
            </c:manualLayout>
          </c:layout>
        </c:title>
        <c:numFmt formatCode="General" sourceLinked="1"/>
        <c:tickLblPos val="nextTo"/>
        <c:spPr>
          <a:ln w="19050">
            <a:solidFill>
              <a:prstClr val="black"/>
            </a:solidFill>
          </a:ln>
        </c:spPr>
        <c:crossAx val="67067904"/>
        <c:crosses val="autoZero"/>
        <c:crossBetween val="between"/>
      </c:valAx>
      <c:spPr>
        <a:noFill/>
      </c:spPr>
    </c:plotArea>
    <c:plotVisOnly val="1"/>
  </c:chart>
  <c:externalData r:id="rId1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layout>
        <c:manualLayout>
          <c:xMode val="edge"/>
          <c:yMode val="edge"/>
          <c:x val="0.34316090975201613"/>
          <c:y val="2.777777777777779E-2"/>
        </c:manualLayout>
      </c:layout>
      <c:txPr>
        <a:bodyPr/>
        <a:lstStyle/>
        <a:p>
          <a:pPr>
            <a:defRPr sz="1100"/>
          </a:pPr>
          <a:endParaRPr lang="en-US"/>
        </a:p>
      </c:txPr>
    </c:title>
    <c:plotArea>
      <c:layout>
        <c:manualLayout>
          <c:layoutTarget val="inner"/>
          <c:xMode val="edge"/>
          <c:yMode val="edge"/>
          <c:x val="0.14698075363455868"/>
          <c:y val="0.10604615802335077"/>
          <c:w val="0.79617172427853311"/>
          <c:h val="0.66359380939451829"/>
        </c:manualLayout>
      </c:layout>
      <c:barChart>
        <c:barDir val="col"/>
        <c:grouping val="clustered"/>
        <c:ser>
          <c:idx val="0"/>
          <c:order val="0"/>
          <c:tx>
            <c:strRef>
              <c:f>Cold!$A$52</c:f>
              <c:strCache>
                <c:ptCount val="1"/>
                <c:pt idx="0">
                  <c:v>Chapronin21</c:v>
                </c:pt>
              </c:strCache>
            </c:strRef>
          </c:tx>
          <c:spPr>
            <a:solidFill>
              <a:prstClr val="white"/>
            </a:solidFill>
            <a:ln w="19050">
              <a:solidFill>
                <a:prstClr val="black"/>
              </a:solidFill>
            </a:ln>
          </c:spPr>
          <c:errBars>
            <c:errBarType val="both"/>
            <c:errValType val="cust"/>
            <c:plus>
              <c:numRef>
                <c:f>Cold!$F$52:$H$52</c:f>
                <c:numCache>
                  <c:formatCode>General</c:formatCode>
                  <c:ptCount val="3"/>
                  <c:pt idx="0">
                    <c:v>6.2409244507518509E-3</c:v>
                  </c:pt>
                  <c:pt idx="1">
                    <c:v>5.8824213126910333E-3</c:v>
                  </c:pt>
                  <c:pt idx="2">
                    <c:v>9.9956614588534547E-3</c:v>
                  </c:pt>
                </c:numCache>
              </c:numRef>
            </c:plus>
            <c:minus>
              <c:numRef>
                <c:f>Cold!$F$52:$H$52</c:f>
                <c:numCache>
                  <c:formatCode>General</c:formatCode>
                  <c:ptCount val="3"/>
                  <c:pt idx="0">
                    <c:v>6.2409244507518509E-3</c:v>
                  </c:pt>
                  <c:pt idx="1">
                    <c:v>5.8824213126910333E-3</c:v>
                  </c:pt>
                  <c:pt idx="2">
                    <c:v>9.9956614588534547E-3</c:v>
                  </c:pt>
                </c:numCache>
              </c:numRef>
            </c:minus>
          </c:errBars>
          <c:cat>
            <c:strRef>
              <c:f>Cold!$B$1:$D$1</c:f>
              <c:strCache>
                <c:ptCount val="3"/>
                <c:pt idx="0">
                  <c:v>COLD_24H</c:v>
                </c:pt>
                <c:pt idx="1">
                  <c:v>COLD_48H</c:v>
                </c:pt>
                <c:pt idx="2">
                  <c:v>COLD_72H</c:v>
                </c:pt>
              </c:strCache>
            </c:strRef>
          </c:cat>
          <c:val>
            <c:numRef>
              <c:f>Cold!$B$52:$D$52</c:f>
              <c:numCache>
                <c:formatCode>General</c:formatCode>
                <c:ptCount val="3"/>
                <c:pt idx="0">
                  <c:v>0.34316539902715332</c:v>
                </c:pt>
                <c:pt idx="1">
                  <c:v>0.25857012464564066</c:v>
                </c:pt>
                <c:pt idx="2">
                  <c:v>0.2718006855379585</c:v>
                </c:pt>
              </c:numCache>
            </c:numRef>
          </c:val>
        </c:ser>
        <c:axId val="67094016"/>
        <c:axId val="67095552"/>
      </c:barChart>
      <c:catAx>
        <c:axId val="67094016"/>
        <c:scaling>
          <c:orientation val="minMax"/>
        </c:scaling>
        <c:axPos val="b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67095552"/>
        <c:crosses val="autoZero"/>
        <c:auto val="1"/>
        <c:lblAlgn val="ctr"/>
        <c:lblOffset val="100"/>
      </c:catAx>
      <c:valAx>
        <c:axId val="67095552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b="1" i="0" baseline="0" dirty="0"/>
                  <a:t>RQ</a:t>
                </a:r>
                <a:endParaRPr lang="en-US" sz="1000" dirty="0"/>
              </a:p>
            </c:rich>
          </c:tx>
          <c:layout>
            <c:manualLayout>
              <c:xMode val="edge"/>
              <c:yMode val="edge"/>
              <c:x val="4.5552482677891203E-3"/>
              <c:y val="0.34298191892680091"/>
            </c:manualLayout>
          </c:layout>
        </c:title>
        <c:numFmt formatCode="General" sourceLinked="1"/>
        <c:tickLblPos val="nextTo"/>
        <c:spPr>
          <a:ln w="19050">
            <a:solidFill>
              <a:prstClr val="black"/>
            </a:solidFill>
          </a:ln>
        </c:spPr>
        <c:crossAx val="67094016"/>
        <c:crosses val="autoZero"/>
        <c:crossBetween val="between"/>
      </c:valAx>
    </c:plotArea>
    <c:plotVisOnly val="1"/>
  </c:chart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en-US"/>
  <c:chart>
    <c:title>
      <c:tx>
        <c:rich>
          <a:bodyPr/>
          <a:lstStyle/>
          <a:p>
            <a:pPr>
              <a:defRPr sz="1100"/>
            </a:pPr>
            <a:r>
              <a:rPr lang="en-US" sz="1100" b="1" i="0" u="none" strike="noStrike" baseline="0" dirty="0" smtClean="0"/>
              <a:t>Cold stress induced protein</a:t>
            </a:r>
            <a:endParaRPr lang="en-US" dirty="0"/>
          </a:p>
        </c:rich>
      </c:tx>
      <c:layout>
        <c:manualLayout>
          <c:xMode val="edge"/>
          <c:yMode val="edge"/>
          <c:x val="0.18169425498035971"/>
          <c:y val="2.777777777777779E-2"/>
        </c:manualLayout>
      </c:layout>
    </c:title>
    <c:plotArea>
      <c:layout>
        <c:manualLayout>
          <c:layoutTarget val="inner"/>
          <c:xMode val="edge"/>
          <c:yMode val="edge"/>
          <c:x val="0.11073480356788072"/>
          <c:y val="5.6504811898512704E-2"/>
          <c:w val="0.83083226150516043"/>
          <c:h val="0.71176655001458289"/>
        </c:manualLayout>
      </c:layout>
      <c:barChart>
        <c:barDir val="col"/>
        <c:grouping val="clustered"/>
        <c:ser>
          <c:idx val="0"/>
          <c:order val="0"/>
          <c:tx>
            <c:strRef>
              <c:f>Cold!$A$50</c:f>
              <c:strCache>
                <c:ptCount val="1"/>
                <c:pt idx="0">
                  <c:v>COLD_Sip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prstClr val="black"/>
              </a:solidFill>
            </a:ln>
          </c:spPr>
          <c:errBars>
            <c:errBarType val="both"/>
            <c:errValType val="cust"/>
            <c:plus>
              <c:numRef>
                <c:f>Cold!$F$50:$H$50</c:f>
                <c:numCache>
                  <c:formatCode>General</c:formatCode>
                  <c:ptCount val="3"/>
                  <c:pt idx="0">
                    <c:v>5.8447325212537232E-2</c:v>
                  </c:pt>
                  <c:pt idx="1">
                    <c:v>0.10973448715877997</c:v>
                  </c:pt>
                  <c:pt idx="2">
                    <c:v>1.492419572372302E-2</c:v>
                  </c:pt>
                </c:numCache>
              </c:numRef>
            </c:plus>
            <c:minus>
              <c:numRef>
                <c:f>Cold!$F$50:$H$50</c:f>
                <c:numCache>
                  <c:formatCode>General</c:formatCode>
                  <c:ptCount val="3"/>
                  <c:pt idx="0">
                    <c:v>5.8447325212537232E-2</c:v>
                  </c:pt>
                  <c:pt idx="1">
                    <c:v>0.10973448715877997</c:v>
                  </c:pt>
                  <c:pt idx="2">
                    <c:v>1.492419572372302E-2</c:v>
                  </c:pt>
                </c:numCache>
              </c:numRef>
            </c:minus>
          </c:errBars>
          <c:cat>
            <c:strRef>
              <c:f>Cold!$B$1:$D$1</c:f>
              <c:strCache>
                <c:ptCount val="3"/>
                <c:pt idx="0">
                  <c:v>COLD_24H</c:v>
                </c:pt>
                <c:pt idx="1">
                  <c:v>COLD_48H</c:v>
                </c:pt>
                <c:pt idx="2">
                  <c:v>COLD_72H</c:v>
                </c:pt>
              </c:strCache>
            </c:strRef>
          </c:cat>
          <c:val>
            <c:numRef>
              <c:f>Cold!$B$50:$D$50</c:f>
              <c:numCache>
                <c:formatCode>General</c:formatCode>
                <c:ptCount val="3"/>
                <c:pt idx="0">
                  <c:v>0.94037787428488295</c:v>
                </c:pt>
                <c:pt idx="1">
                  <c:v>1.0946472224251793</c:v>
                </c:pt>
                <c:pt idx="2">
                  <c:v>1.9482934620696106</c:v>
                </c:pt>
              </c:numCache>
            </c:numRef>
          </c:val>
        </c:ser>
        <c:axId val="61624704"/>
        <c:axId val="61626240"/>
      </c:barChart>
      <c:catAx>
        <c:axId val="61624704"/>
        <c:scaling>
          <c:orientation val="minMax"/>
        </c:scaling>
        <c:axPos val="b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61626240"/>
        <c:crosses val="autoZero"/>
        <c:auto val="1"/>
        <c:lblAlgn val="ctr"/>
        <c:lblOffset val="100"/>
      </c:catAx>
      <c:valAx>
        <c:axId val="61626240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b="1" i="0" baseline="0"/>
                  <a:t>RQ</a:t>
                </a:r>
                <a:endParaRPr lang="en-US" sz="1000"/>
              </a:p>
            </c:rich>
          </c:tx>
          <c:layout>
            <c:manualLayout>
              <c:xMode val="edge"/>
              <c:yMode val="edge"/>
              <c:x val="4.2916656528873796E-2"/>
              <c:y val="0.28465733449985425"/>
            </c:manualLayout>
          </c:layout>
        </c:title>
        <c:numFmt formatCode="General" sourceLinked="1"/>
        <c:tickLblPos val="nextTo"/>
        <c:spPr>
          <a:ln w="19050">
            <a:solidFill>
              <a:prstClr val="black"/>
            </a:solidFill>
          </a:ln>
        </c:spPr>
        <c:crossAx val="61624704"/>
        <c:crosses val="autoZero"/>
        <c:crossBetween val="between"/>
      </c:valAx>
      <c:spPr>
        <a:noFill/>
      </c:spPr>
    </c:plotArea>
    <c:plotVisOnly val="1"/>
  </c:chart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layout/>
      <c:txPr>
        <a:bodyPr/>
        <a:lstStyle/>
        <a:p>
          <a:pPr>
            <a:defRPr sz="1100"/>
          </a:pPr>
          <a:endParaRPr lang="en-US"/>
        </a:p>
      </c:txPr>
    </c:title>
    <c:plotArea>
      <c:layout>
        <c:manualLayout>
          <c:layoutTarget val="inner"/>
          <c:xMode val="edge"/>
          <c:yMode val="edge"/>
          <c:x val="7.9002187226597048E-2"/>
          <c:y val="5.3391294838145711E-2"/>
          <c:w val="0.89044225721784753"/>
          <c:h val="0.52802566345873458"/>
        </c:manualLayout>
      </c:layout>
      <c:barChart>
        <c:barDir val="col"/>
        <c:grouping val="clustered"/>
        <c:ser>
          <c:idx val="0"/>
          <c:order val="0"/>
          <c:tx>
            <c:strRef>
              <c:f>SALt!$A$45</c:f>
              <c:strCache>
                <c:ptCount val="1"/>
                <c:pt idx="0">
                  <c:v>DEAD Box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prstClr val="black"/>
              </a:solidFill>
            </a:ln>
          </c:spPr>
          <c:errBars>
            <c:errBarType val="both"/>
            <c:errValType val="cust"/>
            <c:plus>
              <c:numRef>
                <c:f>SALt!$H$45:$L$45</c:f>
                <c:numCache>
                  <c:formatCode>General</c:formatCode>
                  <c:ptCount val="5"/>
                  <c:pt idx="0">
                    <c:v>1.0798934762280606E-2</c:v>
                  </c:pt>
                  <c:pt idx="1">
                    <c:v>9.4992724984601998E-3</c:v>
                  </c:pt>
                  <c:pt idx="2">
                    <c:v>2.4706310934657191E-3</c:v>
                  </c:pt>
                  <c:pt idx="3">
                    <c:v>2.0836315521221858E-2</c:v>
                  </c:pt>
                  <c:pt idx="4">
                    <c:v>3.9607172134602214E-2</c:v>
                  </c:pt>
                </c:numCache>
              </c:numRef>
            </c:plus>
            <c:minus>
              <c:numRef>
                <c:f>SALt!$H$45:$L$45</c:f>
                <c:numCache>
                  <c:formatCode>General</c:formatCode>
                  <c:ptCount val="5"/>
                  <c:pt idx="0">
                    <c:v>1.0798934762280606E-2</c:v>
                  </c:pt>
                  <c:pt idx="1">
                    <c:v>9.4992724984601998E-3</c:v>
                  </c:pt>
                  <c:pt idx="2">
                    <c:v>2.4706310934657191E-3</c:v>
                  </c:pt>
                  <c:pt idx="3">
                    <c:v>2.0836315521221858E-2</c:v>
                  </c:pt>
                  <c:pt idx="4">
                    <c:v>3.9607172134602214E-2</c:v>
                  </c:pt>
                </c:numCache>
              </c:numRef>
            </c:minus>
          </c:errBars>
          <c:cat>
            <c:strRef>
              <c:f>SALt!$B$1:$F$1</c:f>
              <c:strCache>
                <c:ptCount val="5"/>
                <c:pt idx="0">
                  <c:v>SALT_25</c:v>
                </c:pt>
                <c:pt idx="1">
                  <c:v>SALT_50</c:v>
                </c:pt>
                <c:pt idx="2">
                  <c:v>SALT_75</c:v>
                </c:pt>
                <c:pt idx="3">
                  <c:v>SALT_100</c:v>
                </c:pt>
                <c:pt idx="4">
                  <c:v>SALT_125</c:v>
                </c:pt>
              </c:strCache>
            </c:strRef>
          </c:cat>
          <c:val>
            <c:numRef>
              <c:f>SALt!$B$45:$F$45</c:f>
              <c:numCache>
                <c:formatCode>General</c:formatCode>
                <c:ptCount val="5"/>
                <c:pt idx="0">
                  <c:v>1.1379068797640679</c:v>
                </c:pt>
                <c:pt idx="1">
                  <c:v>1.1101853034119014</c:v>
                </c:pt>
                <c:pt idx="2">
                  <c:v>0.82020901177555161</c:v>
                </c:pt>
                <c:pt idx="3">
                  <c:v>1.926294786634577</c:v>
                </c:pt>
                <c:pt idx="4">
                  <c:v>2.2479119083087578</c:v>
                </c:pt>
              </c:numCache>
            </c:numRef>
          </c:val>
        </c:ser>
        <c:axId val="64187392"/>
        <c:axId val="64213760"/>
      </c:barChart>
      <c:catAx>
        <c:axId val="64187392"/>
        <c:scaling>
          <c:orientation val="minMax"/>
        </c:scaling>
        <c:axPos val="b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64213760"/>
        <c:crosses val="autoZero"/>
        <c:auto val="1"/>
        <c:lblAlgn val="ctr"/>
        <c:lblOffset val="100"/>
      </c:catAx>
      <c:valAx>
        <c:axId val="64213760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b="1" i="0" baseline="0"/>
                  <a:t>RQ</a:t>
                </a:r>
                <a:endParaRPr lang="en-US" sz="1000"/>
              </a:p>
            </c:rich>
          </c:tx>
          <c:layout/>
        </c:title>
        <c:numFmt formatCode="General" sourceLinked="1"/>
        <c:tickLblPos val="nextTo"/>
        <c:spPr>
          <a:ln w="19050">
            <a:solidFill>
              <a:prstClr val="black"/>
            </a:solidFill>
          </a:ln>
        </c:spPr>
        <c:crossAx val="64187392"/>
        <c:crosses val="autoZero"/>
        <c:crossBetween val="between"/>
      </c:valAx>
      <c:spPr>
        <a:noFill/>
      </c:spPr>
    </c:plotArea>
    <c:plotVisOnly val="1"/>
  </c:chart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100"/>
            </a:pPr>
            <a:r>
              <a:rPr lang="en-US" dirty="0" smtClean="0"/>
              <a:t>Salt</a:t>
            </a:r>
            <a:r>
              <a:rPr lang="en-US" baseline="0" dirty="0" smtClean="0"/>
              <a:t> </a:t>
            </a:r>
            <a:r>
              <a:rPr lang="en-US" dirty="0" smtClean="0"/>
              <a:t>Overlay Stress 1 protein</a:t>
            </a:r>
            <a:endParaRPr lang="en-US" dirty="0"/>
          </a:p>
        </c:rich>
      </c:tx>
      <c:layout/>
    </c:title>
    <c:plotArea>
      <c:layout>
        <c:manualLayout>
          <c:layoutTarget val="inner"/>
          <c:xMode val="edge"/>
          <c:yMode val="edge"/>
          <c:x val="7.9002187226597048E-2"/>
          <c:y val="6.7280183727034107E-2"/>
          <c:w val="0.89044225721784753"/>
          <c:h val="0.54523547250894167"/>
        </c:manualLayout>
      </c:layout>
      <c:barChart>
        <c:barDir val="col"/>
        <c:grouping val="clustered"/>
        <c:ser>
          <c:idx val="0"/>
          <c:order val="0"/>
          <c:tx>
            <c:strRef>
              <c:f>SALt!$A$46</c:f>
              <c:strCache>
                <c:ptCount val="1"/>
                <c:pt idx="0">
                  <c:v>SOS1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prstClr val="black"/>
              </a:solidFill>
            </a:ln>
          </c:spPr>
          <c:errBars>
            <c:errBarType val="both"/>
            <c:errValType val="cust"/>
            <c:plus>
              <c:numRef>
                <c:f>SALt!$H$46:$L$46</c:f>
                <c:numCache>
                  <c:formatCode>General</c:formatCode>
                  <c:ptCount val="5"/>
                  <c:pt idx="0">
                    <c:v>8.8741901038918505E-3</c:v>
                  </c:pt>
                  <c:pt idx="1">
                    <c:v>1.1192793239401927E-2</c:v>
                  </c:pt>
                  <c:pt idx="2">
                    <c:v>1.7269668916918175E-2</c:v>
                  </c:pt>
                  <c:pt idx="3">
                    <c:v>3.2871980043800375E-2</c:v>
                  </c:pt>
                  <c:pt idx="4">
                    <c:v>5.7989827125106653E-3</c:v>
                  </c:pt>
                </c:numCache>
              </c:numRef>
            </c:plus>
            <c:minus>
              <c:numRef>
                <c:f>SALt!$H$46:$L$46</c:f>
                <c:numCache>
                  <c:formatCode>General</c:formatCode>
                  <c:ptCount val="5"/>
                  <c:pt idx="0">
                    <c:v>8.8741901038918505E-3</c:v>
                  </c:pt>
                  <c:pt idx="1">
                    <c:v>1.1192793239401927E-2</c:v>
                  </c:pt>
                  <c:pt idx="2">
                    <c:v>1.7269668916918175E-2</c:v>
                  </c:pt>
                  <c:pt idx="3">
                    <c:v>3.2871980043800375E-2</c:v>
                  </c:pt>
                  <c:pt idx="4">
                    <c:v>5.7989827125106653E-3</c:v>
                  </c:pt>
                </c:numCache>
              </c:numRef>
            </c:minus>
          </c:errBars>
          <c:cat>
            <c:strRef>
              <c:f>SALt!$B$1:$F$1</c:f>
              <c:strCache>
                <c:ptCount val="5"/>
                <c:pt idx="0">
                  <c:v>SALT_25</c:v>
                </c:pt>
                <c:pt idx="1">
                  <c:v>SALT_50</c:v>
                </c:pt>
                <c:pt idx="2">
                  <c:v>SALT_75</c:v>
                </c:pt>
                <c:pt idx="3">
                  <c:v>SALT_100</c:v>
                </c:pt>
                <c:pt idx="4">
                  <c:v>SALT_125</c:v>
                </c:pt>
              </c:strCache>
            </c:strRef>
          </c:cat>
          <c:val>
            <c:numRef>
              <c:f>SALt!$B$46:$F$46</c:f>
              <c:numCache>
                <c:formatCode>General</c:formatCode>
                <c:ptCount val="5"/>
                <c:pt idx="0">
                  <c:v>0.52037047022105998</c:v>
                </c:pt>
                <c:pt idx="1">
                  <c:v>0.66936707767838599</c:v>
                </c:pt>
                <c:pt idx="2">
                  <c:v>0.5066367025966767</c:v>
                </c:pt>
                <c:pt idx="3">
                  <c:v>0.92980784283022155</c:v>
                </c:pt>
                <c:pt idx="4">
                  <c:v>0.95655113575015749</c:v>
                </c:pt>
              </c:numCache>
            </c:numRef>
          </c:val>
        </c:ser>
        <c:axId val="64369408"/>
        <c:axId val="64370944"/>
      </c:barChart>
      <c:catAx>
        <c:axId val="64369408"/>
        <c:scaling>
          <c:orientation val="minMax"/>
        </c:scaling>
        <c:axPos val="b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64370944"/>
        <c:crosses val="autoZero"/>
        <c:auto val="1"/>
        <c:lblAlgn val="ctr"/>
        <c:lblOffset val="100"/>
      </c:catAx>
      <c:valAx>
        <c:axId val="64370944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b="1" i="0" baseline="0"/>
                  <a:t>RQ</a:t>
                </a:r>
                <a:endParaRPr lang="en-US" sz="1000"/>
              </a:p>
            </c:rich>
          </c:tx>
          <c:layout>
            <c:manualLayout>
              <c:xMode val="edge"/>
              <c:yMode val="edge"/>
              <c:x val="1.2209988732199376E-2"/>
              <c:y val="0.35684522595297358"/>
            </c:manualLayout>
          </c:layout>
        </c:title>
        <c:numFmt formatCode="General" sourceLinked="1"/>
        <c:tickLblPos val="nextTo"/>
        <c:spPr>
          <a:ln w="19050">
            <a:solidFill>
              <a:schemeClr val="tx1"/>
            </a:solidFill>
          </a:ln>
        </c:spPr>
        <c:crossAx val="64369408"/>
        <c:crosses val="autoZero"/>
        <c:crossBetween val="between"/>
      </c:valAx>
      <c:spPr>
        <a:noFill/>
      </c:spPr>
    </c:plotArea>
    <c:plotVisOnly val="1"/>
  </c:chart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autoTitleDeleted val="1"/>
    <c:plotArea>
      <c:layout>
        <c:manualLayout>
          <c:layoutTarget val="inner"/>
          <c:xMode val="edge"/>
          <c:yMode val="edge"/>
          <c:x val="4.1473972003499546E-2"/>
          <c:y val="4.2635658914728779E-2"/>
          <c:w val="0.94626257655293056"/>
          <c:h val="0.51978731188378202"/>
        </c:manualLayout>
      </c:layout>
      <c:barChart>
        <c:barDir val="col"/>
        <c:grouping val="clustered"/>
        <c:ser>
          <c:idx val="0"/>
          <c:order val="0"/>
          <c:dPt>
            <c:idx val="0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1"/>
            <c:spPr>
              <a:solidFill>
                <a:schemeClr val="bg1">
                  <a:lumMod val="65000"/>
                </a:schemeClr>
              </a:solidFill>
            </c:spPr>
          </c:dPt>
          <c:dPt>
            <c:idx val="2"/>
            <c:spPr>
              <a:solidFill>
                <a:schemeClr val="bg1">
                  <a:lumMod val="65000"/>
                </a:schemeClr>
              </a:solidFill>
            </c:spPr>
          </c:dPt>
          <c:dPt>
            <c:idx val="3"/>
            <c:spPr>
              <a:solidFill>
                <a:schemeClr val="bg1">
                  <a:lumMod val="65000"/>
                </a:schemeClr>
              </a:solidFill>
            </c:spPr>
          </c:dPt>
          <c:dPt>
            <c:idx val="4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5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6"/>
            <c:spPr>
              <a:solidFill>
                <a:schemeClr val="bg1">
                  <a:lumMod val="65000"/>
                </a:schemeClr>
              </a:solidFill>
            </c:spPr>
          </c:dPt>
          <c:dPt>
            <c:idx val="7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8"/>
            <c:spPr>
              <a:solidFill>
                <a:schemeClr val="bg1">
                  <a:lumMod val="65000"/>
                </a:schemeClr>
              </a:solidFill>
            </c:spPr>
          </c:dPt>
          <c:dPt>
            <c:idx val="9"/>
            <c:spPr>
              <a:solidFill>
                <a:schemeClr val="bg1">
                  <a:lumMod val="65000"/>
                </a:schemeClr>
              </a:solidFill>
            </c:spPr>
          </c:dPt>
          <c:dPt>
            <c:idx val="10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11"/>
            <c:spPr>
              <a:solidFill>
                <a:schemeClr val="bg1">
                  <a:lumMod val="65000"/>
                </a:schemeClr>
              </a:solidFill>
            </c:spPr>
          </c:dPt>
          <c:dPt>
            <c:idx val="12"/>
            <c:spPr>
              <a:solidFill>
                <a:schemeClr val="bg1">
                  <a:lumMod val="65000"/>
                </a:schemeClr>
              </a:solidFill>
            </c:spPr>
          </c:dPt>
          <c:dPt>
            <c:idx val="13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14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15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16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17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18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19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20"/>
            <c:spPr>
              <a:solidFill>
                <a:schemeClr val="bg1">
                  <a:lumMod val="65000"/>
                </a:schemeClr>
              </a:solidFill>
            </c:spPr>
          </c:dPt>
          <c:dPt>
            <c:idx val="21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22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23"/>
            <c:spPr>
              <a:solidFill>
                <a:schemeClr val="bg1">
                  <a:lumMod val="65000"/>
                </a:schemeClr>
              </a:solidFill>
            </c:spPr>
          </c:dPt>
          <c:dPt>
            <c:idx val="24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25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26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27"/>
            <c:spPr>
              <a:solidFill>
                <a:schemeClr val="bg1">
                  <a:lumMod val="65000"/>
                </a:schemeClr>
              </a:solidFill>
            </c:spPr>
          </c:dPt>
          <c:dPt>
            <c:idx val="28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29"/>
            <c:spPr>
              <a:solidFill>
                <a:schemeClr val="bg1">
                  <a:lumMod val="65000"/>
                </a:schemeClr>
              </a:solidFill>
            </c:spPr>
          </c:dPt>
          <c:dPt>
            <c:idx val="30"/>
            <c:spPr>
              <a:solidFill>
                <a:schemeClr val="bg1">
                  <a:lumMod val="65000"/>
                </a:schemeClr>
              </a:solidFill>
            </c:spPr>
          </c:dPt>
          <c:dPt>
            <c:idx val="31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32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33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34"/>
            <c:spPr>
              <a:solidFill>
                <a:schemeClr val="bg1">
                  <a:lumMod val="65000"/>
                </a:schemeClr>
              </a:solidFill>
            </c:spPr>
          </c:dPt>
          <c:dPt>
            <c:idx val="35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36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37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38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39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40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41"/>
            <c:spPr>
              <a:solidFill>
                <a:schemeClr val="bg1">
                  <a:lumMod val="65000"/>
                </a:schemeClr>
              </a:solidFill>
            </c:spPr>
          </c:dPt>
          <c:dPt>
            <c:idx val="42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43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44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45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46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47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48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49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50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51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52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53"/>
            <c:spPr>
              <a:solidFill>
                <a:schemeClr val="tx1">
                  <a:lumMod val="95000"/>
                  <a:lumOff val="5000"/>
                </a:schemeClr>
              </a:solidFill>
            </c:spPr>
          </c:dPt>
          <c:dPt>
            <c:idx val="54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Pt>
            <c:idx val="55"/>
            <c:spPr>
              <a:solidFill>
                <a:schemeClr val="lt1"/>
              </a:solidFill>
              <a:ln w="25400" cap="flat" cmpd="sng" algn="ctr">
                <a:solidFill>
                  <a:schemeClr val="dk1"/>
                </a:solidFill>
                <a:prstDash val="solid"/>
              </a:ln>
              <a:effectLst/>
            </c:spPr>
          </c:dPt>
          <c:dLbls>
            <c:delete val="1"/>
          </c:dLbls>
          <c:errBars>
            <c:errBarType val="both"/>
            <c:errValType val="cust"/>
            <c:plus>
              <c:numRef>
                <c:f>Flood!$C$2:$C$57</c:f>
                <c:numCache>
                  <c:formatCode>General</c:formatCode>
                  <c:ptCount val="56"/>
                  <c:pt idx="0">
                    <c:v>2.1351796364709071E-2</c:v>
                  </c:pt>
                  <c:pt idx="1">
                    <c:v>7.5400210291482292E-2</c:v>
                  </c:pt>
                  <c:pt idx="2">
                    <c:v>2.7575750252715091E-2</c:v>
                  </c:pt>
                  <c:pt idx="3">
                    <c:v>4.9063311119411E-2</c:v>
                  </c:pt>
                  <c:pt idx="4">
                    <c:v>0.10186156025704732</c:v>
                  </c:pt>
                  <c:pt idx="5">
                    <c:v>6.8665018200682895E-2</c:v>
                  </c:pt>
                  <c:pt idx="6">
                    <c:v>4.3195031942340714E-2</c:v>
                  </c:pt>
                  <c:pt idx="7">
                    <c:v>5.8938057318680223E-2</c:v>
                  </c:pt>
                  <c:pt idx="8">
                    <c:v>2.5028751626878083E-2</c:v>
                  </c:pt>
                  <c:pt idx="9">
                    <c:v>8.8388347648238048E-4</c:v>
                  </c:pt>
                  <c:pt idx="10">
                    <c:v>3.5913246309684801E-2</c:v>
                  </c:pt>
                  <c:pt idx="11">
                    <c:v>0.17224909057657992</c:v>
                  </c:pt>
                  <c:pt idx="12">
                    <c:v>2.157665632112642E-2</c:v>
                  </c:pt>
                  <c:pt idx="13">
                    <c:v>5.9137461430973932E-2</c:v>
                  </c:pt>
                  <c:pt idx="14">
                    <c:v>3.3259474559891922E-2</c:v>
                  </c:pt>
                  <c:pt idx="15">
                    <c:v>0.12053978588209006</c:v>
                  </c:pt>
                  <c:pt idx="16">
                    <c:v>2.2146584386760794E-2</c:v>
                  </c:pt>
                  <c:pt idx="17">
                    <c:v>1.0462351934433983E-2</c:v>
                  </c:pt>
                  <c:pt idx="18">
                    <c:v>8.3148686399736067E-3</c:v>
                  </c:pt>
                  <c:pt idx="19">
                    <c:v>9.2131063841140087E-2</c:v>
                  </c:pt>
                  <c:pt idx="20">
                    <c:v>3.0154568683700516E-2</c:v>
                  </c:pt>
                  <c:pt idx="21">
                    <c:v>1.243871538785218E-2</c:v>
                  </c:pt>
                  <c:pt idx="22">
                    <c:v>0.16113054354940276</c:v>
                  </c:pt>
                  <c:pt idx="23">
                    <c:v>1.5267142512599316E-2</c:v>
                  </c:pt>
                  <c:pt idx="24">
                    <c:v>1.0062129496278003E-3</c:v>
                  </c:pt>
                  <c:pt idx="25">
                    <c:v>2.4748737341521742E-3</c:v>
                  </c:pt>
                  <c:pt idx="26">
                    <c:v>6.6197215534339812E-2</c:v>
                  </c:pt>
                  <c:pt idx="27">
                    <c:v>6.6137111457939962E-2</c:v>
                  </c:pt>
                  <c:pt idx="28">
                    <c:v>7.5767905817700584E-2</c:v>
                  </c:pt>
                  <c:pt idx="29">
                    <c:v>5.1073615698323221E-2</c:v>
                  </c:pt>
                  <c:pt idx="30">
                    <c:v>6.5152818818528913E-2</c:v>
                  </c:pt>
                  <c:pt idx="31">
                    <c:v>6.8975438077623838E-2</c:v>
                  </c:pt>
                  <c:pt idx="32">
                    <c:v>1.6860254090612398E-2</c:v>
                  </c:pt>
                  <c:pt idx="33">
                    <c:v>4.8832087201961451E-2</c:v>
                  </c:pt>
                  <c:pt idx="34">
                    <c:v>6.1383939674799094E-3</c:v>
                  </c:pt>
                  <c:pt idx="35">
                    <c:v>2.5605043653544716E-2</c:v>
                  </c:pt>
                  <c:pt idx="36">
                    <c:v>8.1040801085010092E-2</c:v>
                  </c:pt>
                  <c:pt idx="37">
                    <c:v>8.3721442892508453E-3</c:v>
                  </c:pt>
                  <c:pt idx="38">
                    <c:v>8.1317279836464421E-3</c:v>
                  </c:pt>
                  <c:pt idx="39">
                    <c:v>0.13449453820880455</c:v>
                  </c:pt>
                  <c:pt idx="40">
                    <c:v>5.9169988342909173E-2</c:v>
                  </c:pt>
                  <c:pt idx="41">
                    <c:v>0.11743558711268062</c:v>
                  </c:pt>
                  <c:pt idx="42">
                    <c:v>1.3046120112890311E-2</c:v>
                  </c:pt>
                  <c:pt idx="43">
                    <c:v>1.1320779566797673E-2</c:v>
                  </c:pt>
                  <c:pt idx="44">
                    <c:v>6.3250701577141364E-3</c:v>
                  </c:pt>
                  <c:pt idx="45">
                    <c:v>0.14478506319541479</c:v>
                  </c:pt>
                  <c:pt idx="46">
                    <c:v>8.3680430699177272E-2</c:v>
                  </c:pt>
                  <c:pt idx="47">
                    <c:v>2.502309477263031E-2</c:v>
                  </c:pt>
                  <c:pt idx="48">
                    <c:v>1.0714081948538921E-2</c:v>
                  </c:pt>
                  <c:pt idx="49">
                    <c:v>3.4293971780766208E-2</c:v>
                  </c:pt>
                  <c:pt idx="50">
                    <c:v>3.2601158146606357E-2</c:v>
                  </c:pt>
                  <c:pt idx="51">
                    <c:v>9.9977827791967108E-3</c:v>
                  </c:pt>
                  <c:pt idx="52">
                    <c:v>1.5506851711421805E-2</c:v>
                  </c:pt>
                  <c:pt idx="53">
                    <c:v>4.480228565598693E-3</c:v>
                  </c:pt>
                  <c:pt idx="54">
                    <c:v>1.4917124655911421E-2</c:v>
                  </c:pt>
                  <c:pt idx="55">
                    <c:v>2.5117139974529395E-2</c:v>
                  </c:pt>
                </c:numCache>
              </c:numRef>
            </c:plus>
            <c:minus>
              <c:numRef>
                <c:f>Flood!$C$2:$C$57</c:f>
                <c:numCache>
                  <c:formatCode>General</c:formatCode>
                  <c:ptCount val="56"/>
                  <c:pt idx="0">
                    <c:v>2.1351796364709071E-2</c:v>
                  </c:pt>
                  <c:pt idx="1">
                    <c:v>7.5400210291482292E-2</c:v>
                  </c:pt>
                  <c:pt idx="2">
                    <c:v>2.7575750252715091E-2</c:v>
                  </c:pt>
                  <c:pt idx="3">
                    <c:v>4.9063311119411E-2</c:v>
                  </c:pt>
                  <c:pt idx="4">
                    <c:v>0.10186156025704732</c:v>
                  </c:pt>
                  <c:pt idx="5">
                    <c:v>6.8665018200682895E-2</c:v>
                  </c:pt>
                  <c:pt idx="6">
                    <c:v>4.3195031942340714E-2</c:v>
                  </c:pt>
                  <c:pt idx="7">
                    <c:v>5.8938057318680223E-2</c:v>
                  </c:pt>
                  <c:pt idx="8">
                    <c:v>2.5028751626878083E-2</c:v>
                  </c:pt>
                  <c:pt idx="9">
                    <c:v>8.8388347648238048E-4</c:v>
                  </c:pt>
                  <c:pt idx="10">
                    <c:v>3.5913246309684801E-2</c:v>
                  </c:pt>
                  <c:pt idx="11">
                    <c:v>0.17224909057657992</c:v>
                  </c:pt>
                  <c:pt idx="12">
                    <c:v>2.157665632112642E-2</c:v>
                  </c:pt>
                  <c:pt idx="13">
                    <c:v>5.9137461430973932E-2</c:v>
                  </c:pt>
                  <c:pt idx="14">
                    <c:v>3.3259474559891922E-2</c:v>
                  </c:pt>
                  <c:pt idx="15">
                    <c:v>0.12053978588209006</c:v>
                  </c:pt>
                  <c:pt idx="16">
                    <c:v>2.2146584386760794E-2</c:v>
                  </c:pt>
                  <c:pt idx="17">
                    <c:v>1.0462351934433983E-2</c:v>
                  </c:pt>
                  <c:pt idx="18">
                    <c:v>8.3148686399736067E-3</c:v>
                  </c:pt>
                  <c:pt idx="19">
                    <c:v>9.2131063841140087E-2</c:v>
                  </c:pt>
                  <c:pt idx="20">
                    <c:v>3.0154568683700516E-2</c:v>
                  </c:pt>
                  <c:pt idx="21">
                    <c:v>1.243871538785218E-2</c:v>
                  </c:pt>
                  <c:pt idx="22">
                    <c:v>0.16113054354940276</c:v>
                  </c:pt>
                  <c:pt idx="23">
                    <c:v>1.5267142512599316E-2</c:v>
                  </c:pt>
                  <c:pt idx="24">
                    <c:v>1.0062129496278003E-3</c:v>
                  </c:pt>
                  <c:pt idx="25">
                    <c:v>2.4748737341521742E-3</c:v>
                  </c:pt>
                  <c:pt idx="26">
                    <c:v>6.6197215534339812E-2</c:v>
                  </c:pt>
                  <c:pt idx="27">
                    <c:v>6.6137111457939962E-2</c:v>
                  </c:pt>
                  <c:pt idx="28">
                    <c:v>7.5767905817700584E-2</c:v>
                  </c:pt>
                  <c:pt idx="29">
                    <c:v>5.1073615698323221E-2</c:v>
                  </c:pt>
                  <c:pt idx="30">
                    <c:v>6.5152818818528913E-2</c:v>
                  </c:pt>
                  <c:pt idx="31">
                    <c:v>6.8975438077623838E-2</c:v>
                  </c:pt>
                  <c:pt idx="32">
                    <c:v>1.6860254090612398E-2</c:v>
                  </c:pt>
                  <c:pt idx="33">
                    <c:v>4.8832087201961451E-2</c:v>
                  </c:pt>
                  <c:pt idx="34">
                    <c:v>6.1383939674799094E-3</c:v>
                  </c:pt>
                  <c:pt idx="35">
                    <c:v>2.5605043653544716E-2</c:v>
                  </c:pt>
                  <c:pt idx="36">
                    <c:v>8.1040801085010092E-2</c:v>
                  </c:pt>
                  <c:pt idx="37">
                    <c:v>8.3721442892508453E-3</c:v>
                  </c:pt>
                  <c:pt idx="38">
                    <c:v>8.1317279836464421E-3</c:v>
                  </c:pt>
                  <c:pt idx="39">
                    <c:v>0.13449453820880455</c:v>
                  </c:pt>
                  <c:pt idx="40">
                    <c:v>5.9169988342909173E-2</c:v>
                  </c:pt>
                  <c:pt idx="41">
                    <c:v>0.11743558711268062</c:v>
                  </c:pt>
                  <c:pt idx="42">
                    <c:v>1.3046120112890311E-2</c:v>
                  </c:pt>
                  <c:pt idx="43">
                    <c:v>1.1320779566797673E-2</c:v>
                  </c:pt>
                  <c:pt idx="44">
                    <c:v>6.3250701577141364E-3</c:v>
                  </c:pt>
                  <c:pt idx="45">
                    <c:v>0.14478506319541479</c:v>
                  </c:pt>
                  <c:pt idx="46">
                    <c:v>8.3680430699177272E-2</c:v>
                  </c:pt>
                  <c:pt idx="47">
                    <c:v>2.502309477263031E-2</c:v>
                  </c:pt>
                  <c:pt idx="48">
                    <c:v>1.0714081948538921E-2</c:v>
                  </c:pt>
                  <c:pt idx="49">
                    <c:v>3.4293971780766208E-2</c:v>
                  </c:pt>
                  <c:pt idx="50">
                    <c:v>3.2601158146606357E-2</c:v>
                  </c:pt>
                  <c:pt idx="51">
                    <c:v>9.9977827791967108E-3</c:v>
                  </c:pt>
                  <c:pt idx="52">
                    <c:v>1.5506851711421805E-2</c:v>
                  </c:pt>
                  <c:pt idx="53">
                    <c:v>4.480228565598693E-3</c:v>
                  </c:pt>
                  <c:pt idx="54">
                    <c:v>1.4917124655911421E-2</c:v>
                  </c:pt>
                  <c:pt idx="55">
                    <c:v>2.5117139974529395E-2</c:v>
                  </c:pt>
                </c:numCache>
              </c:numRef>
            </c:minus>
          </c:errBars>
          <c:cat>
            <c:strRef>
              <c:f>Flood!$A$2:$A$57</c:f>
              <c:strCache>
                <c:ptCount val="56"/>
                <c:pt idx="0">
                  <c:v>NAC2</c:v>
                </c:pt>
                <c:pt idx="1">
                  <c:v>SmHSP-17.4BCII</c:v>
                </c:pt>
                <c:pt idx="2">
                  <c:v>SmHSP-17.9Cl</c:v>
                </c:pt>
                <c:pt idx="3">
                  <c:v>SmHSP.4797-5192</c:v>
                </c:pt>
                <c:pt idx="4">
                  <c:v>Dehydrin2</c:v>
                </c:pt>
                <c:pt idx="5">
                  <c:v>WRKYII</c:v>
                </c:pt>
                <c:pt idx="6">
                  <c:v>SmHSP-25.1CP</c:v>
                </c:pt>
                <c:pt idx="7">
                  <c:v>Dehydrin1</c:v>
                </c:pt>
                <c:pt idx="8">
                  <c:v>cdPK1</c:v>
                </c:pt>
                <c:pt idx="9">
                  <c:v>MAPK2</c:v>
                </c:pt>
                <c:pt idx="10">
                  <c:v>DoubleWRKY</c:v>
                </c:pt>
                <c:pt idx="11">
                  <c:v>MAPKK</c:v>
                </c:pt>
                <c:pt idx="12">
                  <c:v>MAPKKK</c:v>
                </c:pt>
                <c:pt idx="13">
                  <c:v>WRKY</c:v>
                </c:pt>
                <c:pt idx="14">
                  <c:v>MyBC05</c:v>
                </c:pt>
                <c:pt idx="15">
                  <c:v>MyB1</c:v>
                </c:pt>
                <c:pt idx="16">
                  <c:v>CRBF</c:v>
                </c:pt>
                <c:pt idx="17">
                  <c:v>bZIP</c:v>
                </c:pt>
                <c:pt idx="18">
                  <c:v>CAT</c:v>
                </c:pt>
                <c:pt idx="19">
                  <c:v>Ferritin</c:v>
                </c:pt>
                <c:pt idx="20">
                  <c:v>cdkl3</c:v>
                </c:pt>
                <c:pt idx="21">
                  <c:v>LEA</c:v>
                </c:pt>
                <c:pt idx="22">
                  <c:v>MYC-RP</c:v>
                </c:pt>
                <c:pt idx="23">
                  <c:v>Dehydration induced Protein</c:v>
                </c:pt>
                <c:pt idx="24">
                  <c:v>DHAR2</c:v>
                </c:pt>
                <c:pt idx="25">
                  <c:v>COR</c:v>
                </c:pt>
                <c:pt idx="26">
                  <c:v>MDHAR</c:v>
                </c:pt>
                <c:pt idx="27">
                  <c:v>CaCmPk</c:v>
                </c:pt>
                <c:pt idx="28">
                  <c:v>NAC1</c:v>
                </c:pt>
                <c:pt idx="29">
                  <c:v>MAPK</c:v>
                </c:pt>
                <c:pt idx="30">
                  <c:v>cdka1</c:v>
                </c:pt>
                <c:pt idx="31">
                  <c:v>GST</c:v>
                </c:pt>
                <c:pt idx="32">
                  <c:v>MyB-P1</c:v>
                </c:pt>
                <c:pt idx="33">
                  <c:v>WRKYI</c:v>
                </c:pt>
                <c:pt idx="34">
                  <c:v>SmHSP-16.6Cl</c:v>
                </c:pt>
                <c:pt idx="35">
                  <c:v>Inducer CBF</c:v>
                </c:pt>
                <c:pt idx="36">
                  <c:v>MyB_Mixta2</c:v>
                </c:pt>
                <c:pt idx="37">
                  <c:v>ABA8'hydroxylase</c:v>
                </c:pt>
                <c:pt idx="38">
                  <c:v>Jasmonate_ZIM</c:v>
                </c:pt>
                <c:pt idx="39">
                  <c:v>ERF1</c:v>
                </c:pt>
                <c:pt idx="40">
                  <c:v>DHAR</c:v>
                </c:pt>
                <c:pt idx="41">
                  <c:v>SmHSP-35.9</c:v>
                </c:pt>
                <c:pt idx="42">
                  <c:v>MyB_Mixta</c:v>
                </c:pt>
                <c:pt idx="43">
                  <c:v>MyC-GP</c:v>
                </c:pt>
                <c:pt idx="44">
                  <c:v>GP</c:v>
                </c:pt>
                <c:pt idx="45">
                  <c:v>AP2</c:v>
                </c:pt>
                <c:pt idx="46">
                  <c:v>MyB4</c:v>
                </c:pt>
                <c:pt idx="47">
                  <c:v>cdkR</c:v>
                </c:pt>
                <c:pt idx="48">
                  <c:v>MyB2</c:v>
                </c:pt>
                <c:pt idx="49">
                  <c:v>SOD-Fe</c:v>
                </c:pt>
                <c:pt idx="50">
                  <c:v>CAT</c:v>
                </c:pt>
                <c:pt idx="51">
                  <c:v>HSP70</c:v>
                </c:pt>
                <c:pt idx="52">
                  <c:v>MyB</c:v>
                </c:pt>
                <c:pt idx="53">
                  <c:v>Hypoxia responsive</c:v>
                </c:pt>
                <c:pt idx="54">
                  <c:v>SOD-CZ</c:v>
                </c:pt>
                <c:pt idx="55">
                  <c:v>SOD-CZ2</c:v>
                </c:pt>
              </c:strCache>
            </c:strRef>
          </c:cat>
          <c:val>
            <c:numRef>
              <c:f>Flood!$B$2:$B$57</c:f>
              <c:numCache>
                <c:formatCode>General</c:formatCode>
                <c:ptCount val="56"/>
                <c:pt idx="0">
                  <c:v>14.612898873833515</c:v>
                </c:pt>
                <c:pt idx="1">
                  <c:v>4.5013195946026903</c:v>
                </c:pt>
                <c:pt idx="2">
                  <c:v>3.0065136320993826</c:v>
                </c:pt>
                <c:pt idx="3">
                  <c:v>2.610383005269846</c:v>
                </c:pt>
                <c:pt idx="4">
                  <c:v>2.2948215959783971</c:v>
                </c:pt>
                <c:pt idx="5">
                  <c:v>1.9112890792360071</c:v>
                </c:pt>
                <c:pt idx="6">
                  <c:v>1.8457370034784597</c:v>
                </c:pt>
                <c:pt idx="7">
                  <c:v>1.7854856017474774</c:v>
                </c:pt>
                <c:pt idx="8">
                  <c:v>1.592379275196834</c:v>
                </c:pt>
                <c:pt idx="9">
                  <c:v>1.504898827886691</c:v>
                </c:pt>
                <c:pt idx="10">
                  <c:v>1.4094751085338979</c:v>
                </c:pt>
                <c:pt idx="11">
                  <c:v>1.3611310721446892</c:v>
                </c:pt>
                <c:pt idx="12">
                  <c:v>1.3564816203938821</c:v>
                </c:pt>
                <c:pt idx="13">
                  <c:v>1.2832591078311166</c:v>
                </c:pt>
                <c:pt idx="14">
                  <c:v>1.2527955558901118</c:v>
                </c:pt>
                <c:pt idx="15">
                  <c:v>1.2248868625997629</c:v>
                </c:pt>
                <c:pt idx="16">
                  <c:v>1.1922799304969038</c:v>
                </c:pt>
                <c:pt idx="17">
                  <c:v>1.1274621487346559</c:v>
                </c:pt>
                <c:pt idx="18">
                  <c:v>1.089365059680675</c:v>
                </c:pt>
                <c:pt idx="19">
                  <c:v>1.0496286467276597</c:v>
                </c:pt>
                <c:pt idx="20">
                  <c:v>1.0012657940464116</c:v>
                </c:pt>
                <c:pt idx="21">
                  <c:v>0.98896748887485819</c:v>
                </c:pt>
                <c:pt idx="22">
                  <c:v>0.92166284651453911</c:v>
                </c:pt>
                <c:pt idx="23">
                  <c:v>0.8868853372667117</c:v>
                </c:pt>
                <c:pt idx="24">
                  <c:v>0.85427116990940699</c:v>
                </c:pt>
                <c:pt idx="25">
                  <c:v>0.75714131544878183</c:v>
                </c:pt>
                <c:pt idx="26">
                  <c:v>0.70587322328756763</c:v>
                </c:pt>
                <c:pt idx="27">
                  <c:v>0.6880095520589915</c:v>
                </c:pt>
                <c:pt idx="28">
                  <c:v>0.68478713338777164</c:v>
                </c:pt>
                <c:pt idx="29">
                  <c:v>0.6812203791813275</c:v>
                </c:pt>
                <c:pt idx="30">
                  <c:v>0.64640801871596587</c:v>
                </c:pt>
                <c:pt idx="31">
                  <c:v>0.64205153203001053</c:v>
                </c:pt>
                <c:pt idx="32">
                  <c:v>0.61441740929803368</c:v>
                </c:pt>
                <c:pt idx="33">
                  <c:v>0.5933365245828639</c:v>
                </c:pt>
                <c:pt idx="34">
                  <c:v>0.57342809659357041</c:v>
                </c:pt>
                <c:pt idx="35">
                  <c:v>0.55489607369858573</c:v>
                </c:pt>
                <c:pt idx="36">
                  <c:v>0.51806983889321268</c:v>
                </c:pt>
                <c:pt idx="37">
                  <c:v>0.50366957837151705</c:v>
                </c:pt>
                <c:pt idx="38">
                  <c:v>0.50011351573468665</c:v>
                </c:pt>
                <c:pt idx="39">
                  <c:v>0.48701378037426396</c:v>
                </c:pt>
                <c:pt idx="40">
                  <c:v>0.47979183118822244</c:v>
                </c:pt>
                <c:pt idx="41">
                  <c:v>0.46111324136359877</c:v>
                </c:pt>
                <c:pt idx="42">
                  <c:v>0.45066583858404496</c:v>
                </c:pt>
                <c:pt idx="43">
                  <c:v>0.42725669386192017</c:v>
                </c:pt>
                <c:pt idx="44">
                  <c:v>0.42606486760650297</c:v>
                </c:pt>
                <c:pt idx="45">
                  <c:v>0.40211066340879781</c:v>
                </c:pt>
                <c:pt idx="46">
                  <c:v>0.37081949563918043</c:v>
                </c:pt>
                <c:pt idx="47">
                  <c:v>0.36496727124928335</c:v>
                </c:pt>
                <c:pt idx="48">
                  <c:v>0.36079356187831246</c:v>
                </c:pt>
                <c:pt idx="49">
                  <c:v>0.35275550441541476</c:v>
                </c:pt>
                <c:pt idx="50">
                  <c:v>0.33022654501681803</c:v>
                </c:pt>
                <c:pt idx="51">
                  <c:v>0.32711163941749832</c:v>
                </c:pt>
                <c:pt idx="52">
                  <c:v>0.23403788649106363</c:v>
                </c:pt>
                <c:pt idx="53">
                  <c:v>0.21036637098567026</c:v>
                </c:pt>
                <c:pt idx="54">
                  <c:v>0.19573131555194168</c:v>
                </c:pt>
                <c:pt idx="55">
                  <c:v>0.17329014308242355</c:v>
                </c:pt>
              </c:numCache>
            </c:numRef>
          </c:val>
        </c:ser>
        <c:dLbls>
          <c:showVal val="1"/>
        </c:dLbls>
        <c:gapWidth val="75"/>
        <c:axId val="64103168"/>
        <c:axId val="64104704"/>
      </c:barChart>
      <c:catAx>
        <c:axId val="64103168"/>
        <c:scaling>
          <c:orientation val="minMax"/>
        </c:scaling>
        <c:axPos val="b"/>
        <c:majorTickMark val="none"/>
        <c:tickLblPos val="nextTo"/>
        <c:txPr>
          <a:bodyPr/>
          <a:lstStyle/>
          <a:p>
            <a:pPr>
              <a:defRPr sz="700" b="1"/>
            </a:pPr>
            <a:endParaRPr lang="en-US"/>
          </a:p>
        </c:txPr>
        <c:crossAx val="64104704"/>
        <c:crosses val="autoZero"/>
        <c:auto val="1"/>
        <c:lblAlgn val="ctr"/>
        <c:lblOffset val="100"/>
      </c:catAx>
      <c:valAx>
        <c:axId val="64104704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b="1"/>
                </a:pPr>
                <a:r>
                  <a:rPr lang="en-US" b="1"/>
                  <a:t>RQ</a:t>
                </a:r>
              </a:p>
            </c:rich>
          </c:tx>
          <c:layout>
            <c:manualLayout>
              <c:xMode val="edge"/>
              <c:yMode val="edge"/>
              <c:x val="1.854000163502377E-2"/>
              <c:y val="0.28830141741931298"/>
            </c:manualLayout>
          </c:layout>
        </c:title>
        <c:numFmt formatCode="General" sourceLinked="1"/>
        <c:majorTickMark val="none"/>
        <c:tickLblPos val="nextTo"/>
        <c:crossAx val="64103168"/>
        <c:crosses val="autoZero"/>
        <c:crossBetween val="between"/>
        <c:majorUnit val="1"/>
      </c:valAx>
      <c:spPr>
        <a:ln w="19050">
          <a:solidFill>
            <a:schemeClr val="tx1"/>
          </a:solidFill>
        </a:ln>
      </c:spPr>
    </c:plotArea>
    <c:plotVisOnly val="1"/>
  </c:chart>
  <c:spPr>
    <a:ln>
      <a:noFill/>
    </a:ln>
  </c:spPr>
  <c:txPr>
    <a:bodyPr/>
    <a:lstStyle/>
    <a:p>
      <a:pPr>
        <a:defRPr b="0">
          <a:latin typeface="Arial" pitchFamily="34" charset="0"/>
          <a:cs typeface="Arial" pitchFamily="34" charset="0"/>
        </a:defRPr>
      </a:pPr>
      <a:endParaRPr lang="en-US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100"/>
            </a:pPr>
            <a:r>
              <a:rPr lang="en-US" dirty="0" err="1" smtClean="0"/>
              <a:t>Sm</a:t>
            </a:r>
            <a:r>
              <a:rPr lang="en-US" dirty="0" smtClean="0"/>
              <a:t> Heat Shock Protein-17.9Cl</a:t>
            </a:r>
            <a:endParaRPr lang="en-US" dirty="0"/>
          </a:p>
        </c:rich>
      </c:tx>
      <c:layout/>
    </c:title>
    <c:plotArea>
      <c:layout>
        <c:manualLayout>
          <c:layoutTarget val="inner"/>
          <c:xMode val="edge"/>
          <c:yMode val="edge"/>
          <c:x val="0.10340191851018621"/>
          <c:y val="8.6049997426792216E-2"/>
          <c:w val="0.84203458942632159"/>
          <c:h val="0.60956589985075349"/>
        </c:manualLayout>
      </c:layout>
      <c:barChart>
        <c:barDir val="col"/>
        <c:grouping val="clustered"/>
        <c:ser>
          <c:idx val="0"/>
          <c:order val="0"/>
          <c:tx>
            <c:strRef>
              <c:f>Drought!$A$53</c:f>
              <c:strCache>
                <c:ptCount val="1"/>
                <c:pt idx="0">
                  <c:v>SmHSP-17.9Cl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schemeClr val="tx1"/>
              </a:solidFill>
            </a:ln>
          </c:spPr>
          <c:errBars>
            <c:errBarType val="both"/>
            <c:errValType val="cust"/>
            <c:plus>
              <c:numRef>
                <c:f>Drought!$G$53:$J$53</c:f>
                <c:numCache>
                  <c:formatCode>General</c:formatCode>
                  <c:ptCount val="4"/>
                  <c:pt idx="0">
                    <c:v>2.2459125584047553E-2</c:v>
                  </c:pt>
                  <c:pt idx="1">
                    <c:v>1.5431898392614342E-2</c:v>
                  </c:pt>
                  <c:pt idx="2">
                    <c:v>4.1148664917590783E-2</c:v>
                  </c:pt>
                  <c:pt idx="3">
                    <c:v>1.5272799366849601E-2</c:v>
                  </c:pt>
                </c:numCache>
              </c:numRef>
            </c:plus>
            <c:minus>
              <c:numRef>
                <c:f>Drought!$G$53:$J$53</c:f>
                <c:numCache>
                  <c:formatCode>General</c:formatCode>
                  <c:ptCount val="4"/>
                  <c:pt idx="0">
                    <c:v>2.2459125584047553E-2</c:v>
                  </c:pt>
                  <c:pt idx="1">
                    <c:v>1.5431898392614342E-2</c:v>
                  </c:pt>
                  <c:pt idx="2">
                    <c:v>4.1148664917590783E-2</c:v>
                  </c:pt>
                  <c:pt idx="3">
                    <c:v>1.5272799366849601E-2</c:v>
                  </c:pt>
                </c:numCache>
              </c:numRef>
            </c:minus>
          </c:errBars>
          <c:cat>
            <c:strRef>
              <c:f>Drought!$B$1:$E$1</c:f>
              <c:strCache>
                <c:ptCount val="4"/>
                <c:pt idx="0">
                  <c:v>100% FC</c:v>
                </c:pt>
                <c:pt idx="1">
                  <c:v>60% FC</c:v>
                </c:pt>
                <c:pt idx="2">
                  <c:v>40% FC</c:v>
                </c:pt>
                <c:pt idx="3">
                  <c:v>20% FC</c:v>
                </c:pt>
              </c:strCache>
            </c:strRef>
          </c:cat>
          <c:val>
            <c:numRef>
              <c:f>Drought!$B$53:$E$53</c:f>
              <c:numCache>
                <c:formatCode>General</c:formatCode>
                <c:ptCount val="4"/>
                <c:pt idx="0">
                  <c:v>0.26299175942860259</c:v>
                </c:pt>
                <c:pt idx="1">
                  <c:v>0.33478400339871467</c:v>
                </c:pt>
                <c:pt idx="2">
                  <c:v>0.58000450054956698</c:v>
                </c:pt>
                <c:pt idx="3">
                  <c:v>1.9715721403397242</c:v>
                </c:pt>
              </c:numCache>
            </c:numRef>
          </c:val>
        </c:ser>
        <c:axId val="64564224"/>
        <c:axId val="64631552"/>
      </c:barChart>
      <c:catAx>
        <c:axId val="64564224"/>
        <c:scaling>
          <c:orientation val="minMax"/>
        </c:scaling>
        <c:axPos val="b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64631552"/>
        <c:crosses val="autoZero"/>
        <c:auto val="1"/>
        <c:lblAlgn val="ctr"/>
        <c:lblOffset val="100"/>
      </c:catAx>
      <c:valAx>
        <c:axId val="64631552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b="1" i="0" baseline="0"/>
                  <a:t>RQ</a:t>
                </a:r>
                <a:endParaRPr lang="en-US" sz="1000"/>
              </a:p>
            </c:rich>
          </c:tx>
          <c:layout/>
        </c:title>
        <c:numFmt formatCode="General" sourceLinked="1"/>
        <c:tickLblPos val="nextTo"/>
        <c:spPr>
          <a:ln w="19050">
            <a:solidFill>
              <a:prstClr val="black"/>
            </a:solidFill>
          </a:ln>
        </c:spPr>
        <c:crossAx val="64564224"/>
        <c:crosses val="autoZero"/>
        <c:crossBetween val="between"/>
      </c:valAx>
      <c:spPr>
        <a:noFill/>
      </c:spPr>
    </c:plotArea>
    <c:plotVisOnly val="1"/>
  </c:chart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100"/>
            </a:pPr>
            <a:r>
              <a:rPr lang="en-US" dirty="0" err="1" smtClean="0"/>
              <a:t>Sm</a:t>
            </a:r>
            <a:r>
              <a:rPr lang="en-US" dirty="0" smtClean="0"/>
              <a:t> </a:t>
            </a:r>
            <a:r>
              <a:rPr lang="en-US" sz="1100" b="1" i="0" u="none" strike="noStrike" baseline="0" dirty="0" smtClean="0"/>
              <a:t>Heat Shock Protein</a:t>
            </a:r>
            <a:r>
              <a:rPr lang="en-US" dirty="0" smtClean="0"/>
              <a:t>-25.1CP</a:t>
            </a:r>
            <a:endParaRPr lang="en-US" dirty="0"/>
          </a:p>
        </c:rich>
      </c:tx>
      <c:layout/>
    </c:title>
    <c:plotArea>
      <c:layout>
        <c:manualLayout>
          <c:layoutTarget val="inner"/>
          <c:xMode val="edge"/>
          <c:yMode val="edge"/>
          <c:x val="0.10340191851018621"/>
          <c:y val="7.7880062786269341E-2"/>
          <c:w val="0.84203458942632159"/>
          <c:h val="0.61773583449128111"/>
        </c:manualLayout>
      </c:layout>
      <c:barChart>
        <c:barDir val="col"/>
        <c:grouping val="clustered"/>
        <c:ser>
          <c:idx val="0"/>
          <c:order val="0"/>
          <c:tx>
            <c:strRef>
              <c:f>Drought!$A$54</c:f>
              <c:strCache>
                <c:ptCount val="1"/>
                <c:pt idx="0">
                  <c:v>SmHSP-25.1CP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prstClr val="black"/>
              </a:solidFill>
            </a:ln>
          </c:spPr>
          <c:errBars>
            <c:errBarType val="both"/>
            <c:errValType val="cust"/>
            <c:plus>
              <c:numRef>
                <c:f>Drought!$G$54:$J$54</c:f>
                <c:numCache>
                  <c:formatCode>General</c:formatCode>
                  <c:ptCount val="4"/>
                  <c:pt idx="0">
                    <c:v>2.9535143143382434E-2</c:v>
                  </c:pt>
                  <c:pt idx="1">
                    <c:v>2.6331949424605653E-2</c:v>
                  </c:pt>
                  <c:pt idx="2">
                    <c:v>5.1781429586287512E-3</c:v>
                  </c:pt>
                  <c:pt idx="3">
                    <c:v>3.1023602917777844E-2</c:v>
                  </c:pt>
                </c:numCache>
              </c:numRef>
            </c:plus>
            <c:minus>
              <c:numRef>
                <c:f>Drought!$G$54:$J$54</c:f>
                <c:numCache>
                  <c:formatCode>General</c:formatCode>
                  <c:ptCount val="4"/>
                  <c:pt idx="0">
                    <c:v>2.9535143143382434E-2</c:v>
                  </c:pt>
                  <c:pt idx="1">
                    <c:v>2.6331949424605653E-2</c:v>
                  </c:pt>
                  <c:pt idx="2">
                    <c:v>5.1781429586287512E-3</c:v>
                  </c:pt>
                  <c:pt idx="3">
                    <c:v>3.1023602917777844E-2</c:v>
                  </c:pt>
                </c:numCache>
              </c:numRef>
            </c:minus>
          </c:errBars>
          <c:cat>
            <c:strRef>
              <c:f>Drought!$B$1:$E$1</c:f>
              <c:strCache>
                <c:ptCount val="4"/>
                <c:pt idx="0">
                  <c:v>100% FC</c:v>
                </c:pt>
                <c:pt idx="1">
                  <c:v>60% FC</c:v>
                </c:pt>
                <c:pt idx="2">
                  <c:v>40% FC</c:v>
                </c:pt>
                <c:pt idx="3">
                  <c:v>20% FC</c:v>
                </c:pt>
              </c:strCache>
            </c:strRef>
          </c:cat>
          <c:val>
            <c:numRef>
              <c:f>Drought!$B$54:$E$54</c:f>
              <c:numCache>
                <c:formatCode>General</c:formatCode>
                <c:ptCount val="4"/>
                <c:pt idx="0">
                  <c:v>0.8973993225303476</c:v>
                </c:pt>
                <c:pt idx="1">
                  <c:v>0.86165186675392702</c:v>
                </c:pt>
                <c:pt idx="2">
                  <c:v>1.1784765080926369</c:v>
                </c:pt>
                <c:pt idx="3">
                  <c:v>2.3307592620294653</c:v>
                </c:pt>
              </c:numCache>
            </c:numRef>
          </c:val>
        </c:ser>
        <c:axId val="64660224"/>
        <c:axId val="64661760"/>
      </c:barChart>
      <c:catAx>
        <c:axId val="64660224"/>
        <c:scaling>
          <c:orientation val="minMax"/>
        </c:scaling>
        <c:axPos val="b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64661760"/>
        <c:crosses val="autoZero"/>
        <c:auto val="1"/>
        <c:lblAlgn val="ctr"/>
        <c:lblOffset val="100"/>
      </c:catAx>
      <c:valAx>
        <c:axId val="64661760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b="1" i="0" baseline="0"/>
                  <a:t>RQ</a:t>
                </a:r>
                <a:endParaRPr lang="en-US" sz="1000"/>
              </a:p>
            </c:rich>
          </c:tx>
          <c:layout/>
        </c:title>
        <c:numFmt formatCode="General" sourceLinked="1"/>
        <c:tickLblPos val="nextTo"/>
        <c:spPr>
          <a:ln w="19050">
            <a:solidFill>
              <a:prstClr val="black"/>
            </a:solidFill>
          </a:ln>
        </c:spPr>
        <c:crossAx val="64660224"/>
        <c:crosses val="autoZero"/>
        <c:crossBetween val="between"/>
      </c:valAx>
      <c:spPr>
        <a:noFill/>
      </c:spPr>
    </c:plotArea>
    <c:plotVisOnly val="1"/>
  </c:chart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100"/>
            </a:pPr>
            <a:r>
              <a:rPr lang="en-US" dirty="0" err="1" smtClean="0"/>
              <a:t>Sm</a:t>
            </a:r>
            <a:r>
              <a:rPr lang="en-US" dirty="0" smtClean="0"/>
              <a:t> </a:t>
            </a:r>
            <a:r>
              <a:rPr lang="en-US" sz="1100" b="1" i="0" u="none" strike="noStrike" baseline="0" dirty="0" smtClean="0"/>
              <a:t>Heat Shock Protein</a:t>
            </a:r>
            <a:r>
              <a:rPr lang="en-US" dirty="0" smtClean="0"/>
              <a:t>-35.9</a:t>
            </a:r>
            <a:endParaRPr lang="en-US" dirty="0"/>
          </a:p>
        </c:rich>
      </c:tx>
      <c:layout>
        <c:manualLayout>
          <c:xMode val="edge"/>
          <c:yMode val="edge"/>
          <c:x val="0.1207587332833398"/>
          <c:y val="5.7189542483660011E-2"/>
        </c:manualLayout>
      </c:layout>
    </c:title>
    <c:plotArea>
      <c:layout>
        <c:manualLayout>
          <c:layoutTarget val="inner"/>
          <c:xMode val="edge"/>
          <c:yMode val="edge"/>
          <c:x val="0.10340191851018621"/>
          <c:y val="8.6049997426792216E-2"/>
          <c:w val="0.84203458942632159"/>
          <c:h val="0.60956589985075349"/>
        </c:manualLayout>
      </c:layout>
      <c:barChart>
        <c:barDir val="col"/>
        <c:grouping val="clustered"/>
        <c:ser>
          <c:idx val="0"/>
          <c:order val="0"/>
          <c:tx>
            <c:strRef>
              <c:f>Drought!$A$55</c:f>
              <c:strCache>
                <c:ptCount val="1"/>
                <c:pt idx="0">
                  <c:v>SmHSP-35.9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prstClr val="black"/>
              </a:solidFill>
            </a:ln>
          </c:spPr>
          <c:errBars>
            <c:errBarType val="both"/>
            <c:errValType val="cust"/>
            <c:plus>
              <c:numRef>
                <c:f>Drought!$G$55:$J$55</c:f>
                <c:numCache>
                  <c:formatCode>General</c:formatCode>
                  <c:ptCount val="4"/>
                  <c:pt idx="0">
                    <c:v>2.7753234054789452E-2</c:v>
                  </c:pt>
                  <c:pt idx="1">
                    <c:v>3.2954711537198735E-2</c:v>
                  </c:pt>
                  <c:pt idx="2">
                    <c:v>9.0629876144668175E-3</c:v>
                  </c:pt>
                  <c:pt idx="3">
                    <c:v>5.0480353108898314E-3</c:v>
                  </c:pt>
                </c:numCache>
              </c:numRef>
            </c:plus>
            <c:minus>
              <c:numRef>
                <c:f>Drought!$G$55:$J$55</c:f>
                <c:numCache>
                  <c:formatCode>General</c:formatCode>
                  <c:ptCount val="4"/>
                  <c:pt idx="0">
                    <c:v>2.7753234054789452E-2</c:v>
                  </c:pt>
                  <c:pt idx="1">
                    <c:v>3.2954711537198735E-2</c:v>
                  </c:pt>
                  <c:pt idx="2">
                    <c:v>9.0629876144668175E-3</c:v>
                  </c:pt>
                  <c:pt idx="3">
                    <c:v>5.0480353108898314E-3</c:v>
                  </c:pt>
                </c:numCache>
              </c:numRef>
            </c:minus>
          </c:errBars>
          <c:cat>
            <c:strRef>
              <c:f>Drought!$B$1:$E$1</c:f>
              <c:strCache>
                <c:ptCount val="4"/>
                <c:pt idx="0">
                  <c:v>100% FC</c:v>
                </c:pt>
                <c:pt idx="1">
                  <c:v>60% FC</c:v>
                </c:pt>
                <c:pt idx="2">
                  <c:v>40% FC</c:v>
                </c:pt>
                <c:pt idx="3">
                  <c:v>20% FC</c:v>
                </c:pt>
              </c:strCache>
            </c:strRef>
          </c:cat>
          <c:val>
            <c:numRef>
              <c:f>Drought!$B$55:$E$55</c:f>
              <c:numCache>
                <c:formatCode>General</c:formatCode>
                <c:ptCount val="4"/>
                <c:pt idx="0">
                  <c:v>0.62469331653421112</c:v>
                </c:pt>
                <c:pt idx="1">
                  <c:v>0.35490258802787811</c:v>
                </c:pt>
                <c:pt idx="2">
                  <c:v>0.65535476440779061</c:v>
                </c:pt>
                <c:pt idx="3">
                  <c:v>5.512002338063148</c:v>
                </c:pt>
              </c:numCache>
            </c:numRef>
          </c:val>
        </c:ser>
        <c:axId val="64678144"/>
        <c:axId val="67125248"/>
      </c:barChart>
      <c:catAx>
        <c:axId val="64678144"/>
        <c:scaling>
          <c:orientation val="minMax"/>
        </c:scaling>
        <c:axPos val="b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67125248"/>
        <c:crosses val="autoZero"/>
        <c:auto val="1"/>
        <c:lblAlgn val="ctr"/>
        <c:lblOffset val="100"/>
      </c:catAx>
      <c:valAx>
        <c:axId val="67125248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b="1" i="0" baseline="0"/>
                  <a:t>RQ</a:t>
                </a:r>
                <a:endParaRPr lang="en-US" sz="1000"/>
              </a:p>
            </c:rich>
          </c:tx>
          <c:layout/>
        </c:title>
        <c:numFmt formatCode="General" sourceLinked="1"/>
        <c:tickLblPos val="nextTo"/>
        <c:spPr>
          <a:ln w="19050">
            <a:solidFill>
              <a:prstClr val="black"/>
            </a:solidFill>
          </a:ln>
        </c:spPr>
        <c:crossAx val="64678144"/>
        <c:crosses val="autoZero"/>
        <c:crossBetween val="between"/>
      </c:valAx>
      <c:spPr>
        <a:noFill/>
      </c:spPr>
    </c:plotArea>
    <c:plotVisOnly val="1"/>
  </c:chart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en-US"/>
  <c:chart>
    <c:title>
      <c:tx>
        <c:rich>
          <a:bodyPr/>
          <a:lstStyle/>
          <a:p>
            <a:pPr>
              <a:defRPr sz="1100"/>
            </a:pPr>
            <a:r>
              <a:rPr lang="en-US" dirty="0" smtClean="0"/>
              <a:t>Sodium Calcium </a:t>
            </a:r>
          </a:p>
          <a:p>
            <a:pPr>
              <a:defRPr sz="1100"/>
            </a:pPr>
            <a:r>
              <a:rPr lang="en-US" dirty="0" smtClean="0"/>
              <a:t>Exchanger</a:t>
            </a:r>
            <a:endParaRPr lang="en-US" dirty="0"/>
          </a:p>
        </c:rich>
      </c:tx>
      <c:layout>
        <c:manualLayout>
          <c:xMode val="edge"/>
          <c:yMode val="edge"/>
          <c:x val="0.47528212040226775"/>
          <c:y val="0"/>
        </c:manualLayout>
      </c:layout>
    </c:title>
    <c:plotArea>
      <c:layout>
        <c:manualLayout>
          <c:layoutTarget val="inner"/>
          <c:xMode val="edge"/>
          <c:yMode val="edge"/>
          <c:x val="0.10311836020497438"/>
          <c:y val="5.6504811898512704E-2"/>
          <c:w val="0.88337270341207352"/>
          <c:h val="0.50026246719160095"/>
        </c:manualLayout>
      </c:layout>
      <c:barChart>
        <c:barDir val="col"/>
        <c:grouping val="clustered"/>
        <c:ser>
          <c:idx val="0"/>
          <c:order val="0"/>
          <c:tx>
            <c:strRef>
              <c:f>SALt!$A$42</c:f>
              <c:strCache>
                <c:ptCount val="1"/>
                <c:pt idx="0">
                  <c:v>NaCa.Exchanger</c:v>
                </c:pt>
              </c:strCache>
            </c:strRef>
          </c:tx>
          <c:spPr>
            <a:solidFill>
              <a:schemeClr val="bg1"/>
            </a:solidFill>
            <a:ln w="19050">
              <a:solidFill>
                <a:prstClr val="black"/>
              </a:solidFill>
            </a:ln>
          </c:spPr>
          <c:errBars>
            <c:errBarType val="both"/>
            <c:errValType val="cust"/>
            <c:plus>
              <c:numRef>
                <c:f>SALt!$H$42:$L$42</c:f>
                <c:numCache>
                  <c:formatCode>General</c:formatCode>
                  <c:ptCount val="5"/>
                  <c:pt idx="0">
                    <c:v>6.4240651070790094E-3</c:v>
                  </c:pt>
                  <c:pt idx="1">
                    <c:v>1.0702061133258963E-2</c:v>
                  </c:pt>
                  <c:pt idx="2">
                    <c:v>4.0499540892459947E-2</c:v>
                  </c:pt>
                  <c:pt idx="3">
                    <c:v>5.7063517241629142E-4</c:v>
                  </c:pt>
                  <c:pt idx="4">
                    <c:v>1.6561855028951394E-2</c:v>
                  </c:pt>
                </c:numCache>
              </c:numRef>
            </c:plus>
            <c:minus>
              <c:numRef>
                <c:f>SALt!$H$42:$L$42</c:f>
                <c:numCache>
                  <c:formatCode>General</c:formatCode>
                  <c:ptCount val="5"/>
                  <c:pt idx="0">
                    <c:v>6.4240651070790094E-3</c:v>
                  </c:pt>
                  <c:pt idx="1">
                    <c:v>1.0702061133258963E-2</c:v>
                  </c:pt>
                  <c:pt idx="2">
                    <c:v>4.0499540892459947E-2</c:v>
                  </c:pt>
                  <c:pt idx="3">
                    <c:v>5.7063517241629142E-4</c:v>
                  </c:pt>
                  <c:pt idx="4">
                    <c:v>1.6561855028951394E-2</c:v>
                  </c:pt>
                </c:numCache>
              </c:numRef>
            </c:minus>
          </c:errBars>
          <c:cat>
            <c:strRef>
              <c:f>SALt!$B$1:$F$1</c:f>
              <c:strCache>
                <c:ptCount val="5"/>
                <c:pt idx="0">
                  <c:v>SALT_25</c:v>
                </c:pt>
                <c:pt idx="1">
                  <c:v>SALT_50</c:v>
                </c:pt>
                <c:pt idx="2">
                  <c:v>SALT_75</c:v>
                </c:pt>
                <c:pt idx="3">
                  <c:v>SALT_100</c:v>
                </c:pt>
                <c:pt idx="4">
                  <c:v>SALT_125</c:v>
                </c:pt>
              </c:strCache>
            </c:strRef>
          </c:cat>
          <c:val>
            <c:numRef>
              <c:f>SALt!$B$42:$F$42</c:f>
              <c:numCache>
                <c:formatCode>General</c:formatCode>
                <c:ptCount val="5"/>
                <c:pt idx="0">
                  <c:v>256.54115943346545</c:v>
                </c:pt>
                <c:pt idx="1">
                  <c:v>209.82263362593096</c:v>
                </c:pt>
                <c:pt idx="2">
                  <c:v>68.379098618285596</c:v>
                </c:pt>
                <c:pt idx="3">
                  <c:v>74.343102955654288</c:v>
                </c:pt>
                <c:pt idx="4">
                  <c:v>35.444490821343187</c:v>
                </c:pt>
              </c:numCache>
            </c:numRef>
          </c:val>
        </c:ser>
        <c:axId val="67145728"/>
        <c:axId val="67147264"/>
      </c:barChart>
      <c:catAx>
        <c:axId val="67145728"/>
        <c:scaling>
          <c:orientation val="minMax"/>
        </c:scaling>
        <c:axPos val="b"/>
        <c:tickLblPos val="nextTo"/>
        <c:spPr>
          <a:ln w="19050">
            <a:solidFill>
              <a:prstClr val="black"/>
            </a:solidFill>
          </a:ln>
        </c:spPr>
        <c:txPr>
          <a:bodyPr/>
          <a:lstStyle/>
          <a:p>
            <a:pPr>
              <a:defRPr b="1"/>
            </a:pPr>
            <a:endParaRPr lang="en-US"/>
          </a:p>
        </c:txPr>
        <c:crossAx val="67147264"/>
        <c:crosses val="autoZero"/>
        <c:auto val="1"/>
        <c:lblAlgn val="ctr"/>
        <c:lblOffset val="100"/>
      </c:catAx>
      <c:valAx>
        <c:axId val="67147264"/>
        <c:scaling>
          <c:orientation val="minMax"/>
        </c:scaling>
        <c:axPos val="l"/>
        <c:title>
          <c:tx>
            <c:rich>
              <a:bodyPr rot="-5400000" vert="horz"/>
              <a:lstStyle/>
              <a:p>
                <a:pPr>
                  <a:defRPr sz="1000"/>
                </a:pPr>
                <a:r>
                  <a:rPr lang="en-US" sz="1000" b="1" i="0" baseline="0"/>
                  <a:t>RQ</a:t>
                </a:r>
                <a:endParaRPr lang="en-US" sz="1000"/>
              </a:p>
            </c:rich>
          </c:tx>
          <c:layout>
            <c:manualLayout>
              <c:xMode val="edge"/>
              <c:yMode val="edge"/>
              <c:x val="6.1309533004804363E-3"/>
              <c:y val="0.22077350625289485"/>
            </c:manualLayout>
          </c:layout>
        </c:title>
        <c:numFmt formatCode="General" sourceLinked="1"/>
        <c:tickLblPos val="nextTo"/>
        <c:spPr>
          <a:ln w="19050">
            <a:solidFill>
              <a:prstClr val="black"/>
            </a:solidFill>
          </a:ln>
        </c:spPr>
        <c:crossAx val="67145728"/>
        <c:crosses val="autoZero"/>
        <c:crossBetween val="between"/>
      </c:valAx>
      <c:spPr>
        <a:noFill/>
        <a:ln w="19050">
          <a:noFill/>
        </a:ln>
      </c:spPr>
    </c:plotArea>
    <c:plotVisOnly val="1"/>
  </c:chart>
  <c:externalData r:id="rId1"/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943FF16-3B2F-478C-830A-905F4ADA730F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AFB1CA8-68C8-4588-8D4D-37CE5CA04BD5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>
            <a:normAutofit/>
          </a:bodyPr>
          <a:lstStyle/>
          <a:p>
            <a:pPr marL="0" marR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1 Fig. </a:t>
            </a:r>
            <a:r>
              <a:rPr lang="en-US" sz="1200" b="1" dirty="0" err="1" smtClean="0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- PCR for determining the optimal stress conditions for selection of samples for transcriptome sequencing.</a:t>
            </a:r>
            <a:endParaRPr lang="en-US" sz="1200" dirty="0" smtClean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AFB1CA8-68C8-4588-8D4D-37CE5CA04BD5}" type="slidenum">
              <a:rPr lang="en-US" smtClean="0"/>
              <a:pPr/>
              <a:t>1</a:t>
            </a:fld>
            <a:endParaRPr 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36CC0-B102-4B6F-9EFD-3E7928C41B65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BC050-0452-4348-8058-A0E6DF9542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36CC0-B102-4B6F-9EFD-3E7928C41B65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BC050-0452-4348-8058-A0E6DF9542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36CC0-B102-4B6F-9EFD-3E7928C41B65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BC050-0452-4348-8058-A0E6DF9542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36CC0-B102-4B6F-9EFD-3E7928C41B65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BC050-0452-4348-8058-A0E6DF9542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36CC0-B102-4B6F-9EFD-3E7928C41B65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BC050-0452-4348-8058-A0E6DF9542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36CC0-B102-4B6F-9EFD-3E7928C41B65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BC050-0452-4348-8058-A0E6DF9542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36CC0-B102-4B6F-9EFD-3E7928C41B65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BC050-0452-4348-8058-A0E6DF9542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36CC0-B102-4B6F-9EFD-3E7928C41B65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BC050-0452-4348-8058-A0E6DF9542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36CC0-B102-4B6F-9EFD-3E7928C41B65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BC050-0452-4348-8058-A0E6DF9542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36CC0-B102-4B6F-9EFD-3E7928C41B65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BC050-0452-4348-8058-A0E6DF9542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036CC0-B102-4B6F-9EFD-3E7928C41B65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3FBC050-0452-4348-8058-A0E6DF954257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036CC0-B102-4B6F-9EFD-3E7928C41B65}" type="datetimeFigureOut">
              <a:rPr lang="en-US" smtClean="0"/>
              <a:pPr/>
              <a:t>10/2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3FBC050-0452-4348-8058-A0E6DF954257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6.xml"/><Relationship Id="rId13" Type="http://schemas.openxmlformats.org/officeDocument/2006/relationships/chart" Target="../charts/chart11.xml"/><Relationship Id="rId3" Type="http://schemas.openxmlformats.org/officeDocument/2006/relationships/chart" Target="../charts/chart1.xml"/><Relationship Id="rId7" Type="http://schemas.openxmlformats.org/officeDocument/2006/relationships/chart" Target="../charts/chart5.xml"/><Relationship Id="rId12" Type="http://schemas.openxmlformats.org/officeDocument/2006/relationships/chart" Target="../charts/chart10.xml"/><Relationship Id="rId17" Type="http://schemas.openxmlformats.org/officeDocument/2006/relationships/chart" Target="../charts/chart15.xml"/><Relationship Id="rId2" Type="http://schemas.openxmlformats.org/officeDocument/2006/relationships/notesSlide" Target="../notesSlides/notesSlide1.xml"/><Relationship Id="rId16" Type="http://schemas.openxmlformats.org/officeDocument/2006/relationships/chart" Target="../charts/chart14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4.xml"/><Relationship Id="rId11" Type="http://schemas.openxmlformats.org/officeDocument/2006/relationships/chart" Target="../charts/chart9.xml"/><Relationship Id="rId5" Type="http://schemas.openxmlformats.org/officeDocument/2006/relationships/chart" Target="../charts/chart3.xml"/><Relationship Id="rId15" Type="http://schemas.openxmlformats.org/officeDocument/2006/relationships/chart" Target="../charts/chart13.xml"/><Relationship Id="rId10" Type="http://schemas.openxmlformats.org/officeDocument/2006/relationships/chart" Target="../charts/chart8.xml"/><Relationship Id="rId4" Type="http://schemas.openxmlformats.org/officeDocument/2006/relationships/chart" Target="../charts/chart2.xml"/><Relationship Id="rId9" Type="http://schemas.openxmlformats.org/officeDocument/2006/relationships/chart" Target="../charts/chart7.xml"/><Relationship Id="rId14" Type="http://schemas.openxmlformats.org/officeDocument/2006/relationships/chart" Target="../charts/chart1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/>
          <p:cNvGrpSpPr/>
          <p:nvPr/>
        </p:nvGrpSpPr>
        <p:grpSpPr>
          <a:xfrm>
            <a:off x="0" y="342900"/>
            <a:ext cx="9144000" cy="6515100"/>
            <a:chOff x="-1783080" y="-152400"/>
            <a:chExt cx="14127480" cy="6629400"/>
          </a:xfrm>
        </p:grpSpPr>
        <p:grpSp>
          <p:nvGrpSpPr>
            <p:cNvPr id="3" name="Group 2"/>
            <p:cNvGrpSpPr/>
            <p:nvPr/>
          </p:nvGrpSpPr>
          <p:grpSpPr>
            <a:xfrm>
              <a:off x="-1783080" y="-152399"/>
              <a:ext cx="14127479" cy="6629399"/>
              <a:chOff x="-1783080" y="-152399"/>
              <a:chExt cx="14127479" cy="6629399"/>
            </a:xfrm>
          </p:grpSpPr>
          <p:graphicFrame>
            <p:nvGraphicFramePr>
              <p:cNvPr id="8" name="Chart 7"/>
              <p:cNvGraphicFramePr/>
              <p:nvPr/>
            </p:nvGraphicFramePr>
            <p:xfrm>
              <a:off x="-1600200" y="381000"/>
              <a:ext cx="2286000" cy="1371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3"/>
              </a:graphicData>
            </a:graphic>
          </p:graphicFrame>
          <p:graphicFrame>
            <p:nvGraphicFramePr>
              <p:cNvPr id="9" name="Chart 8"/>
              <p:cNvGraphicFramePr/>
              <p:nvPr/>
            </p:nvGraphicFramePr>
            <p:xfrm>
              <a:off x="609600" y="381000"/>
              <a:ext cx="2286000" cy="1371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sp>
            <p:nvSpPr>
              <p:cNvPr id="10" name="TextBox 10"/>
              <p:cNvSpPr txBox="1"/>
              <p:nvPr/>
            </p:nvSpPr>
            <p:spPr>
              <a:xfrm>
                <a:off x="-1676399" y="0"/>
                <a:ext cx="4419601" cy="307777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400" b="1" dirty="0" smtClean="0"/>
                  <a:t>TEMPORAL COLD STRESS RESPONSE</a:t>
                </a:r>
                <a:endParaRPr lang="en-US" sz="1400" b="1" dirty="0"/>
              </a:p>
            </p:txBody>
          </p:sp>
          <p:graphicFrame>
            <p:nvGraphicFramePr>
              <p:cNvPr id="11" name="Chart 10"/>
              <p:cNvGraphicFramePr/>
              <p:nvPr/>
            </p:nvGraphicFramePr>
            <p:xfrm>
              <a:off x="5869305" y="3619500"/>
              <a:ext cx="3214008" cy="1371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5"/>
              </a:graphicData>
            </a:graphic>
          </p:graphicFrame>
          <p:graphicFrame>
            <p:nvGraphicFramePr>
              <p:cNvPr id="12" name="Chart 11"/>
              <p:cNvGraphicFramePr/>
              <p:nvPr/>
            </p:nvGraphicFramePr>
            <p:xfrm>
              <a:off x="9054193" y="3520440"/>
              <a:ext cx="3214008" cy="147066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6"/>
              </a:graphicData>
            </a:graphic>
          </p:graphicFrame>
          <p:sp>
            <p:nvSpPr>
              <p:cNvPr id="13" name="TextBox 14"/>
              <p:cNvSpPr txBox="1"/>
              <p:nvPr/>
            </p:nvSpPr>
            <p:spPr>
              <a:xfrm>
                <a:off x="5791201" y="3169920"/>
                <a:ext cx="6400801" cy="307777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400" b="1" dirty="0" smtClean="0"/>
                  <a:t>SALT STRESS RESPONSE</a:t>
                </a:r>
                <a:endParaRPr lang="en-US" sz="1400" b="1" dirty="0"/>
              </a:p>
            </p:txBody>
          </p:sp>
          <p:grpSp>
            <p:nvGrpSpPr>
              <p:cNvPr id="14" name="Group 13"/>
              <p:cNvGrpSpPr/>
              <p:nvPr/>
            </p:nvGrpSpPr>
            <p:grpSpPr>
              <a:xfrm>
                <a:off x="2819400" y="-152399"/>
                <a:ext cx="9524999" cy="3124199"/>
                <a:chOff x="228601" y="1752601"/>
                <a:chExt cx="9524999" cy="3124199"/>
              </a:xfrm>
            </p:grpSpPr>
            <p:graphicFrame>
              <p:nvGraphicFramePr>
                <p:cNvPr id="26" name="Chart 25"/>
                <p:cNvGraphicFramePr/>
                <p:nvPr/>
              </p:nvGraphicFramePr>
              <p:xfrm>
                <a:off x="228601" y="1752601"/>
                <a:ext cx="9524999" cy="3124199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7"/>
                </a:graphicData>
              </a:graphic>
            </p:graphicFrame>
            <p:sp>
              <p:nvSpPr>
                <p:cNvPr id="27" name="TextBox 18"/>
                <p:cNvSpPr txBox="1"/>
                <p:nvPr/>
              </p:nvSpPr>
              <p:spPr>
                <a:xfrm>
                  <a:off x="990603" y="1905000"/>
                  <a:ext cx="8077201" cy="307777"/>
                </a:xfrm>
                <a:prstGeom prst="rect">
                  <a:avLst/>
                </a:prstGeom>
              </p:spPr>
              <p:style>
                <a:lnRef idx="2">
                  <a:schemeClr val="dk1">
                    <a:shade val="50000"/>
                  </a:schemeClr>
                </a:lnRef>
                <a:fillRef idx="1">
                  <a:schemeClr val="dk1"/>
                </a:fillRef>
                <a:effectRef idx="0">
                  <a:schemeClr val="dk1"/>
                </a:effectRef>
                <a:fontRef idx="minor">
                  <a:schemeClr val="lt1"/>
                </a:fontRef>
              </p:style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914400" rtl="0" eaLnBrk="1" latinLnBrk="0" hangingPunct="1">
                    <a:defRPr sz="1800" kern="1200">
                      <a:solidFill>
                        <a:schemeClr val="lt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pPr algn="ctr"/>
                  <a:r>
                    <a:rPr lang="en-US" sz="1400" b="1" dirty="0" smtClean="0"/>
                    <a:t>FLOOD STRESS RESPONSE</a:t>
                  </a:r>
                  <a:endParaRPr lang="en-US" sz="1400" b="1" dirty="0"/>
                </a:p>
              </p:txBody>
            </p:sp>
          </p:grpSp>
          <p:graphicFrame>
            <p:nvGraphicFramePr>
              <p:cNvPr id="15" name="Chart 14"/>
              <p:cNvGraphicFramePr/>
              <p:nvPr/>
            </p:nvGraphicFramePr>
            <p:xfrm>
              <a:off x="-1676400" y="3489444"/>
              <a:ext cx="2560320" cy="155448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8"/>
              </a:graphicData>
            </a:graphic>
          </p:graphicFrame>
          <p:graphicFrame>
            <p:nvGraphicFramePr>
              <p:cNvPr id="16" name="Chart 15"/>
              <p:cNvGraphicFramePr/>
              <p:nvPr/>
            </p:nvGraphicFramePr>
            <p:xfrm>
              <a:off x="762000" y="3479917"/>
              <a:ext cx="2560320" cy="155448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9"/>
              </a:graphicData>
            </a:graphic>
          </p:graphicFrame>
          <p:graphicFrame>
            <p:nvGraphicFramePr>
              <p:cNvPr id="17" name="Chart 16"/>
              <p:cNvGraphicFramePr/>
              <p:nvPr/>
            </p:nvGraphicFramePr>
            <p:xfrm>
              <a:off x="3200400" y="3489442"/>
              <a:ext cx="2560320" cy="155448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0"/>
              </a:graphicData>
            </a:graphic>
          </p:graphicFrame>
          <p:sp>
            <p:nvSpPr>
              <p:cNvPr id="18" name="TextBox 23"/>
              <p:cNvSpPr txBox="1"/>
              <p:nvPr/>
            </p:nvSpPr>
            <p:spPr>
              <a:xfrm>
                <a:off x="-1676399" y="3165832"/>
                <a:ext cx="7315200" cy="307777"/>
              </a:xfrm>
              <a:prstGeom prst="rect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914400" rtl="0" eaLnBrk="1" latinLnBrk="0" hangingPunct="1">
                  <a:defRPr sz="1800" kern="120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ctr"/>
                <a:r>
                  <a:rPr lang="en-US" sz="1400" b="1" dirty="0" smtClean="0"/>
                  <a:t>DROUGHT STRESS RESPONSE</a:t>
                </a:r>
                <a:endParaRPr lang="en-US" sz="1400" b="1" dirty="0"/>
              </a:p>
            </p:txBody>
          </p:sp>
          <p:graphicFrame>
            <p:nvGraphicFramePr>
              <p:cNvPr id="19" name="Chart 18"/>
              <p:cNvGraphicFramePr/>
              <p:nvPr/>
            </p:nvGraphicFramePr>
            <p:xfrm>
              <a:off x="5869305" y="5067300"/>
              <a:ext cx="3200400" cy="12954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1"/>
              </a:graphicData>
            </a:graphic>
          </p:graphicFrame>
          <p:graphicFrame>
            <p:nvGraphicFramePr>
              <p:cNvPr id="20" name="Chart 19"/>
              <p:cNvGraphicFramePr/>
              <p:nvPr/>
            </p:nvGraphicFramePr>
            <p:xfrm>
              <a:off x="9067801" y="4953000"/>
              <a:ext cx="3200400" cy="14097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2"/>
              </a:graphicData>
            </a:graphic>
          </p:graphicFrame>
          <p:graphicFrame>
            <p:nvGraphicFramePr>
              <p:cNvPr id="21" name="Chart 20"/>
              <p:cNvGraphicFramePr/>
              <p:nvPr/>
            </p:nvGraphicFramePr>
            <p:xfrm>
              <a:off x="762000" y="4770120"/>
              <a:ext cx="2484120" cy="155448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3"/>
              </a:graphicData>
            </a:graphic>
          </p:graphicFrame>
          <p:graphicFrame>
            <p:nvGraphicFramePr>
              <p:cNvPr id="22" name="Chart 21"/>
              <p:cNvGraphicFramePr/>
              <p:nvPr/>
            </p:nvGraphicFramePr>
            <p:xfrm>
              <a:off x="3124200" y="4770120"/>
              <a:ext cx="2484120" cy="155448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4"/>
              </a:graphicData>
            </a:graphic>
          </p:graphicFrame>
          <p:graphicFrame>
            <p:nvGraphicFramePr>
              <p:cNvPr id="23" name="Chart 22"/>
              <p:cNvGraphicFramePr/>
              <p:nvPr/>
            </p:nvGraphicFramePr>
            <p:xfrm>
              <a:off x="-1783080" y="4770120"/>
              <a:ext cx="2560320" cy="170688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5"/>
              </a:graphicData>
            </a:graphic>
          </p:graphicFrame>
          <p:graphicFrame>
            <p:nvGraphicFramePr>
              <p:cNvPr id="24" name="Chart 23"/>
              <p:cNvGraphicFramePr/>
              <p:nvPr/>
            </p:nvGraphicFramePr>
            <p:xfrm>
              <a:off x="-1600200" y="1676400"/>
              <a:ext cx="2286000" cy="1371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6"/>
              </a:graphicData>
            </a:graphic>
          </p:graphicFrame>
          <p:graphicFrame>
            <p:nvGraphicFramePr>
              <p:cNvPr id="25" name="Chart 24"/>
              <p:cNvGraphicFramePr/>
              <p:nvPr/>
            </p:nvGraphicFramePr>
            <p:xfrm>
              <a:off x="609600" y="1676400"/>
              <a:ext cx="2286000" cy="1371600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17"/>
              </a:graphicData>
            </a:graphic>
          </p:graphicFrame>
        </p:grpSp>
        <p:sp>
          <p:nvSpPr>
            <p:cNvPr id="4" name="Rectangle 3"/>
            <p:cNvSpPr/>
            <p:nvPr/>
          </p:nvSpPr>
          <p:spPr>
            <a:xfrm>
              <a:off x="-1752600" y="-152400"/>
              <a:ext cx="14097000" cy="6629400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>
              <a:defPPr>
                <a:defRPr lang="en-US"/>
              </a:defPPr>
              <a:lvl1pPr marL="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914400" rtl="0" eaLnBrk="1" latinLnBrk="0" hangingPunct="1">
                <a:defRPr sz="1800" kern="1200">
                  <a:solidFill>
                    <a:schemeClr val="lt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endParaRPr lang="en-US"/>
            </a:p>
          </p:txBody>
        </p:sp>
        <p:cxnSp>
          <p:nvCxnSpPr>
            <p:cNvPr id="5" name="Straight Connector 4"/>
            <p:cNvCxnSpPr>
              <a:stCxn id="4" idx="1"/>
              <a:endCxn id="4" idx="3"/>
            </p:cNvCxnSpPr>
            <p:nvPr/>
          </p:nvCxnSpPr>
          <p:spPr>
            <a:xfrm>
              <a:off x="-1752600" y="3162300"/>
              <a:ext cx="14097000" cy="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" name="Straight Connector 5"/>
            <p:cNvCxnSpPr/>
            <p:nvPr/>
          </p:nvCxnSpPr>
          <p:spPr>
            <a:xfrm>
              <a:off x="5715000" y="3124200"/>
              <a:ext cx="0" cy="335280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Straight Connector 6"/>
            <p:cNvCxnSpPr/>
            <p:nvPr/>
          </p:nvCxnSpPr>
          <p:spPr>
            <a:xfrm>
              <a:off x="2819400" y="-121920"/>
              <a:ext cx="0" cy="3291840"/>
            </a:xfrm>
            <a:prstGeom prst="line">
              <a:avLst/>
            </a:prstGeom>
            <a:ln w="285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28" name="Rectangle 27"/>
          <p:cNvSpPr/>
          <p:nvPr/>
        </p:nvSpPr>
        <p:spPr>
          <a:xfrm>
            <a:off x="0" y="12412"/>
            <a:ext cx="9144000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smtClean="0">
                <a:latin typeface="Times New Roman" pitchFamily="18" charset="0"/>
                <a:cs typeface="Times New Roman" pitchFamily="18" charset="0"/>
              </a:rPr>
              <a:t>S1 Fig</a:t>
            </a:r>
            <a:r>
              <a:rPr lang="en-US" sz="1300" b="1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300" b="1" dirty="0" err="1">
                <a:latin typeface="Times New Roman" pitchFamily="18" charset="0"/>
                <a:cs typeface="Times New Roman" pitchFamily="18" charset="0"/>
              </a:rPr>
              <a:t>qRT</a:t>
            </a:r>
            <a:r>
              <a:rPr lang="en-US" sz="1300" b="1" dirty="0">
                <a:latin typeface="Times New Roman" pitchFamily="18" charset="0"/>
                <a:cs typeface="Times New Roman" pitchFamily="18" charset="0"/>
              </a:rPr>
              <a:t>- PCR for determining the optimal stress conditions for selection of samples for transcriptome sequencing.</a:t>
            </a:r>
            <a:endParaRPr lang="en-US" sz="13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</TotalTime>
  <Words>105</Words>
  <Application>Microsoft Office PowerPoint</Application>
  <PresentationFormat>On-screen Show (4:3)</PresentationFormat>
  <Paragraphs>37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Shubhra</dc:creator>
  <cp:lastModifiedBy>Shubhra</cp:lastModifiedBy>
  <cp:revision>11</cp:revision>
  <dcterms:created xsi:type="dcterms:W3CDTF">2017-09-14T06:01:39Z</dcterms:created>
  <dcterms:modified xsi:type="dcterms:W3CDTF">2018-10-02T07:23:41Z</dcterms:modified>
</cp:coreProperties>
</file>